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66908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40" d="100"/>
          <a:sy n="140" d="100"/>
        </p:scale>
        <p:origin x="-1956" y="2658"/>
      </p:cViewPr>
      <p:guideLst>
        <p:guide orient="horz" pos="3787"/>
        <p:guide pos="84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825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80A18C-E9CF-455F-9CD0-335D1AB304B2}" type="datetimeFigureOut">
              <a:rPr lang="en-GB" smtClean="0"/>
              <a:t>21/03/2016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39925" y="744538"/>
            <a:ext cx="2789238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6750" y="4714877"/>
            <a:ext cx="5335588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5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8250" y="9428165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69B436-D9F4-4E8F-9D7F-43A1465DF6E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9057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DD16D-8C12-475E-B0D9-5B4A9ACD3AC4}" type="datetimeFigureOut">
              <a:rPr lang="de-DE" smtClean="0"/>
              <a:t>21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47A3B-9563-4053-AC0B-DD0AF00B53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4304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DD16D-8C12-475E-B0D9-5B4A9ACD3AC4}" type="datetimeFigureOut">
              <a:rPr lang="de-DE" smtClean="0"/>
              <a:t>21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47A3B-9563-4053-AC0B-DD0AF00B53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6912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DD16D-8C12-475E-B0D9-5B4A9ACD3AC4}" type="datetimeFigureOut">
              <a:rPr lang="de-DE" smtClean="0"/>
              <a:t>21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47A3B-9563-4053-AC0B-DD0AF00B53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2735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DD16D-8C12-475E-B0D9-5B4A9ACD3AC4}" type="datetimeFigureOut">
              <a:rPr lang="de-DE" smtClean="0"/>
              <a:t>21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47A3B-9563-4053-AC0B-DD0AF00B53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85383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DD16D-8C12-475E-B0D9-5B4A9ACD3AC4}" type="datetimeFigureOut">
              <a:rPr lang="de-DE" smtClean="0"/>
              <a:t>21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47A3B-9563-4053-AC0B-DD0AF00B53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4660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DD16D-8C12-475E-B0D9-5B4A9ACD3AC4}" type="datetimeFigureOut">
              <a:rPr lang="de-DE" smtClean="0"/>
              <a:t>21.03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47A3B-9563-4053-AC0B-DD0AF00B53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6308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DD16D-8C12-475E-B0D9-5B4A9ACD3AC4}" type="datetimeFigureOut">
              <a:rPr lang="de-DE" smtClean="0"/>
              <a:t>21.03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47A3B-9563-4053-AC0B-DD0AF00B53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2611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DD16D-8C12-475E-B0D9-5B4A9ACD3AC4}" type="datetimeFigureOut">
              <a:rPr lang="de-DE" smtClean="0"/>
              <a:t>21.03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47A3B-9563-4053-AC0B-DD0AF00B53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25606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DD16D-8C12-475E-B0D9-5B4A9ACD3AC4}" type="datetimeFigureOut">
              <a:rPr lang="de-DE" smtClean="0"/>
              <a:t>21.03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47A3B-9563-4053-AC0B-DD0AF00B53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8345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DD16D-8C12-475E-B0D9-5B4A9ACD3AC4}" type="datetimeFigureOut">
              <a:rPr lang="de-DE" smtClean="0"/>
              <a:t>21.03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47A3B-9563-4053-AC0B-DD0AF00B53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1177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DD16D-8C12-475E-B0D9-5B4A9ACD3AC4}" type="datetimeFigureOut">
              <a:rPr lang="de-DE" smtClean="0"/>
              <a:t>21.03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47A3B-9563-4053-AC0B-DD0AF00B53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2733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1DD16D-8C12-475E-B0D9-5B4A9ACD3AC4}" type="datetimeFigureOut">
              <a:rPr lang="de-DE" smtClean="0"/>
              <a:t>21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947A3B-9563-4053-AC0B-DD0AF00B53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5003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oleObject" Target="../embeddings/oleObject1.bin"/><Relationship Id="rId18" Type="http://schemas.openxmlformats.org/officeDocument/2006/relationships/image" Target="../media/image3.emf"/><Relationship Id="rId26" Type="http://schemas.openxmlformats.org/officeDocument/2006/relationships/image" Target="../media/image19.png"/><Relationship Id="rId3" Type="http://schemas.openxmlformats.org/officeDocument/2006/relationships/image" Target="../media/image6.png"/><Relationship Id="rId21" Type="http://schemas.openxmlformats.org/officeDocument/2006/relationships/oleObject" Target="../embeddings/oleObject5.bin"/><Relationship Id="rId7" Type="http://schemas.openxmlformats.org/officeDocument/2006/relationships/image" Target="../media/image10.png"/><Relationship Id="rId12" Type="http://schemas.openxmlformats.org/officeDocument/2006/relationships/image" Target="../media/image15.png"/><Relationship Id="rId17" Type="http://schemas.openxmlformats.org/officeDocument/2006/relationships/oleObject" Target="../embeddings/oleObject3.bin"/><Relationship Id="rId25" Type="http://schemas.openxmlformats.org/officeDocument/2006/relationships/image" Target="../media/image18.pn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.emf"/><Relationship Id="rId20" Type="http://schemas.openxmlformats.org/officeDocument/2006/relationships/image" Target="../media/image4.emf"/><Relationship Id="rId29" Type="http://schemas.openxmlformats.org/officeDocument/2006/relationships/image" Target="../media/image22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24" Type="http://schemas.openxmlformats.org/officeDocument/2006/relationships/image" Target="../media/image17.png"/><Relationship Id="rId32" Type="http://schemas.openxmlformats.org/officeDocument/2006/relationships/image" Target="../media/image25.png"/><Relationship Id="rId5" Type="http://schemas.openxmlformats.org/officeDocument/2006/relationships/image" Target="../media/image8.png"/><Relationship Id="rId15" Type="http://schemas.openxmlformats.org/officeDocument/2006/relationships/oleObject" Target="../embeddings/oleObject2.bin"/><Relationship Id="rId23" Type="http://schemas.openxmlformats.org/officeDocument/2006/relationships/image" Target="../media/image16.png"/><Relationship Id="rId28" Type="http://schemas.openxmlformats.org/officeDocument/2006/relationships/image" Target="../media/image21.png"/><Relationship Id="rId10" Type="http://schemas.openxmlformats.org/officeDocument/2006/relationships/image" Target="../media/image13.png"/><Relationship Id="rId19" Type="http://schemas.openxmlformats.org/officeDocument/2006/relationships/oleObject" Target="../embeddings/oleObject4.bin"/><Relationship Id="rId31" Type="http://schemas.openxmlformats.org/officeDocument/2006/relationships/image" Target="../media/image24.png"/><Relationship Id="rId4" Type="http://schemas.openxmlformats.org/officeDocument/2006/relationships/image" Target="../media/image7.png"/><Relationship Id="rId9" Type="http://schemas.openxmlformats.org/officeDocument/2006/relationships/image" Target="../media/image12.png"/><Relationship Id="rId14" Type="http://schemas.openxmlformats.org/officeDocument/2006/relationships/image" Target="../media/image1.emf"/><Relationship Id="rId22" Type="http://schemas.openxmlformats.org/officeDocument/2006/relationships/image" Target="../media/image5.emf"/><Relationship Id="rId27" Type="http://schemas.openxmlformats.org/officeDocument/2006/relationships/image" Target="../media/image20.png"/><Relationship Id="rId30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916823" y="-36512"/>
            <a:ext cx="30243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Knuschke et al. </a:t>
            </a:r>
            <a:r>
              <a:rPr lang="de-DE" dirty="0" err="1" smtClean="0"/>
              <a:t>Suppl</a:t>
            </a:r>
            <a:r>
              <a:rPr lang="de-DE" dirty="0" smtClean="0"/>
              <a:t>. </a:t>
            </a:r>
            <a:r>
              <a:rPr lang="de-DE" dirty="0" err="1" smtClean="0"/>
              <a:t>Figure</a:t>
            </a:r>
            <a:r>
              <a:rPr lang="de-DE" dirty="0" smtClean="0"/>
              <a:t> 1</a:t>
            </a:r>
            <a:endParaRPr lang="de-DE" dirty="0"/>
          </a:p>
        </p:txBody>
      </p:sp>
      <p:grpSp>
        <p:nvGrpSpPr>
          <p:cNvPr id="5" name="Gruppieren 4"/>
          <p:cNvGrpSpPr/>
          <p:nvPr/>
        </p:nvGrpSpPr>
        <p:grpSpPr>
          <a:xfrm>
            <a:off x="3712963" y="790201"/>
            <a:ext cx="2954649" cy="1044395"/>
            <a:chOff x="3534216" y="1836090"/>
            <a:chExt cx="2954649" cy="1044395"/>
          </a:xfrm>
        </p:grpSpPr>
        <p:cxnSp>
          <p:nvCxnSpPr>
            <p:cNvPr id="6" name="Gerade Verbindung mit Pfeil 5"/>
            <p:cNvCxnSpPr/>
            <p:nvPr/>
          </p:nvCxnSpPr>
          <p:spPr bwMode="auto">
            <a:xfrm>
              <a:off x="4254214" y="2120535"/>
              <a:ext cx="1908211" cy="246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Gerade Verbindung 6"/>
            <p:cNvCxnSpPr/>
            <p:nvPr/>
          </p:nvCxnSpPr>
          <p:spPr bwMode="auto">
            <a:xfrm rot="5400000">
              <a:off x="4090460" y="2293823"/>
              <a:ext cx="346574" cy="0"/>
            </a:xfrm>
            <a:prstGeom prst="line">
              <a:avLst/>
            </a:prstGeom>
            <a:ln w="12700">
              <a:solidFill>
                <a:schemeClr val="tx1"/>
              </a:solidFill>
              <a:head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Gerade Verbindung 7"/>
            <p:cNvCxnSpPr/>
            <p:nvPr/>
          </p:nvCxnSpPr>
          <p:spPr bwMode="auto">
            <a:xfrm rot="5400000">
              <a:off x="5180253" y="2293823"/>
              <a:ext cx="346574" cy="0"/>
            </a:xfrm>
            <a:prstGeom prst="line">
              <a:avLst/>
            </a:prstGeom>
            <a:ln w="12700">
              <a:solidFill>
                <a:schemeClr val="tx1"/>
              </a:solidFill>
              <a:head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Gerade Verbindung 8"/>
            <p:cNvCxnSpPr/>
            <p:nvPr/>
          </p:nvCxnSpPr>
          <p:spPr bwMode="auto">
            <a:xfrm rot="5400000">
              <a:off x="5715598" y="2130397"/>
              <a:ext cx="19722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feld 9"/>
            <p:cNvSpPr txBox="1">
              <a:spLocks noChangeArrowheads="1"/>
            </p:cNvSpPr>
            <p:nvPr/>
          </p:nvSpPr>
          <p:spPr bwMode="auto">
            <a:xfrm>
              <a:off x="5026235" y="2437279"/>
              <a:ext cx="71500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9pPr>
            </a:lstStyle>
            <a:p>
              <a:pPr algn="ctr" eaLnBrk="1" hangingPunct="1"/>
              <a:r>
                <a:rPr lang="de-DE" sz="800" dirty="0" err="1" smtClean="0"/>
                <a:t>vaccination</a:t>
              </a:r>
              <a:endParaRPr lang="de-DE" sz="800" dirty="0"/>
            </a:p>
          </p:txBody>
        </p:sp>
        <p:sp>
          <p:nvSpPr>
            <p:cNvPr id="11" name="Textfeld 10"/>
            <p:cNvSpPr txBox="1"/>
            <p:nvPr/>
          </p:nvSpPr>
          <p:spPr bwMode="auto">
            <a:xfrm>
              <a:off x="3923965" y="1836090"/>
              <a:ext cx="460382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Day 0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 bwMode="auto">
            <a:xfrm>
              <a:off x="5229077" y="1836090"/>
              <a:ext cx="24090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DE" sz="800" b="1" dirty="0">
                  <a:latin typeface="Arial" pitchFamily="34" charset="0"/>
                  <a:cs typeface="Arial" pitchFamily="34" charset="0"/>
                </a:rPr>
                <a:t>42</a:t>
              </a:r>
            </a:p>
          </p:txBody>
        </p:sp>
        <p:sp>
          <p:nvSpPr>
            <p:cNvPr id="13" name="Textfeld 12"/>
            <p:cNvSpPr txBox="1"/>
            <p:nvPr/>
          </p:nvSpPr>
          <p:spPr bwMode="auto">
            <a:xfrm>
              <a:off x="5685129" y="1836090"/>
              <a:ext cx="24090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49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feld 11"/>
            <p:cNvSpPr txBox="1">
              <a:spLocks noChangeArrowheads="1"/>
            </p:cNvSpPr>
            <p:nvPr/>
          </p:nvSpPr>
          <p:spPr bwMode="auto">
            <a:xfrm>
              <a:off x="5661892" y="2418820"/>
              <a:ext cx="661627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9pPr>
            </a:lstStyle>
            <a:p>
              <a:pPr algn="ctr" eaLnBrk="1" hangingPunct="1"/>
              <a:r>
                <a:rPr lang="de-DE" sz="800" dirty="0" err="1" smtClean="0"/>
                <a:t>virus</a:t>
              </a:r>
              <a:r>
                <a:rPr lang="de-DE" sz="800" dirty="0" smtClean="0"/>
                <a:t> </a:t>
              </a:r>
              <a:r>
                <a:rPr lang="de-DE" sz="800" dirty="0" err="1" smtClean="0"/>
                <a:t>titer</a:t>
              </a:r>
              <a:endParaRPr lang="de-DE" sz="800" dirty="0" smtClean="0"/>
            </a:p>
            <a:p>
              <a:pPr algn="ctr" eaLnBrk="1" hangingPunct="1"/>
              <a:r>
                <a:rPr lang="de-DE" sz="800" dirty="0" err="1" smtClean="0"/>
                <a:t>cellular</a:t>
              </a:r>
              <a:r>
                <a:rPr lang="de-DE" sz="800" dirty="0" smtClean="0"/>
                <a:t> </a:t>
              </a:r>
              <a:r>
                <a:rPr lang="de-DE" sz="800" dirty="0" err="1" smtClean="0"/>
                <a:t>analyses</a:t>
              </a:r>
              <a:endParaRPr lang="de-DE" sz="800" dirty="0"/>
            </a:p>
          </p:txBody>
        </p:sp>
        <p:grpSp>
          <p:nvGrpSpPr>
            <p:cNvPr id="15" name="Gruppieren 28"/>
            <p:cNvGrpSpPr/>
            <p:nvPr/>
          </p:nvGrpSpPr>
          <p:grpSpPr>
            <a:xfrm>
              <a:off x="5283161" y="2682901"/>
              <a:ext cx="186824" cy="155319"/>
              <a:chOff x="7896446" y="3317265"/>
              <a:chExt cx="2083832" cy="1952118"/>
            </a:xfrm>
          </p:grpSpPr>
          <p:grpSp>
            <p:nvGrpSpPr>
              <p:cNvPr id="24" name="Gruppieren 105"/>
              <p:cNvGrpSpPr>
                <a:grpSpLocks/>
              </p:cNvGrpSpPr>
              <p:nvPr/>
            </p:nvGrpSpPr>
            <p:grpSpPr bwMode="auto">
              <a:xfrm rot="-6281612">
                <a:off x="8413970" y="4978415"/>
                <a:ext cx="309563" cy="65088"/>
                <a:chOff x="1066800" y="762000"/>
                <a:chExt cx="1268918" cy="493301"/>
              </a:xfrm>
            </p:grpSpPr>
            <p:sp>
              <p:nvSpPr>
                <p:cNvPr id="176" name="Freihandform 175"/>
                <p:cNvSpPr/>
                <p:nvPr/>
              </p:nvSpPr>
              <p:spPr>
                <a:xfrm>
                  <a:off x="1069118" y="752879"/>
                  <a:ext cx="1177816" cy="457202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177" name="Freihandform 176"/>
                <p:cNvSpPr/>
                <p:nvPr/>
              </p:nvSpPr>
              <p:spPr>
                <a:xfrm rot="10586904">
                  <a:off x="1163535" y="798651"/>
                  <a:ext cx="1177812" cy="457202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78" name="Gerade Verbindung 177"/>
                <p:cNvCxnSpPr/>
                <p:nvPr/>
              </p:nvCxnSpPr>
              <p:spPr>
                <a:xfrm>
                  <a:off x="1210791" y="915668"/>
                  <a:ext cx="156174" cy="7219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9" name="Gerade Verbindung 178"/>
                <p:cNvCxnSpPr>
                  <a:stCxn id="177" idx="2"/>
                </p:cNvCxnSpPr>
                <p:nvPr/>
              </p:nvCxnSpPr>
              <p:spPr>
                <a:xfrm rot="10800000" flipV="1">
                  <a:off x="1601823" y="804685"/>
                  <a:ext cx="32534" cy="252661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0" name="Gerade Verbindung 179"/>
                <p:cNvCxnSpPr/>
                <p:nvPr/>
              </p:nvCxnSpPr>
              <p:spPr>
                <a:xfrm rot="16200000" flipH="1">
                  <a:off x="1645807" y="1012358"/>
                  <a:ext cx="216570" cy="650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1" name="Gerade Verbindung 180"/>
                <p:cNvCxnSpPr>
                  <a:endCxn id="177" idx="1"/>
                </p:cNvCxnSpPr>
                <p:nvPr/>
              </p:nvCxnSpPr>
              <p:spPr>
                <a:xfrm rot="5400000">
                  <a:off x="1943542" y="1055710"/>
                  <a:ext cx="300787" cy="1301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" name="Ellipse 24"/>
              <p:cNvSpPr/>
              <p:nvPr/>
            </p:nvSpPr>
            <p:spPr bwMode="auto">
              <a:xfrm>
                <a:off x="7983491" y="3317265"/>
                <a:ext cx="1996787" cy="1951765"/>
              </a:xfrm>
              <a:prstGeom prst="ellipse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</a:ln>
              <a:scene3d>
                <a:camera prst="orthographicFront"/>
                <a:lightRig rig="threePt" dir="t"/>
              </a:scene3d>
              <a:sp3d>
                <a:bevelT w="1905000" h="1905000"/>
              </a:sp3d>
            </p:spPr>
            <p:style>
              <a:lnRef idx="1">
                <a:schemeClr val="accent6"/>
              </a:lnRef>
              <a:fillRef idx="2">
                <a:schemeClr val="accent6"/>
              </a:fillRef>
              <a:effectRef idx="1">
                <a:schemeClr val="accent6"/>
              </a:effectRef>
              <a:fontRef idx="minor">
                <a:schemeClr val="dk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/>
              </a:p>
            </p:txBody>
          </p:sp>
          <p:sp>
            <p:nvSpPr>
              <p:cNvPr id="26" name="Akkord 25"/>
              <p:cNvSpPr/>
              <p:nvPr/>
            </p:nvSpPr>
            <p:spPr bwMode="auto">
              <a:xfrm flipH="1">
                <a:off x="8027863" y="3324991"/>
                <a:ext cx="1808411" cy="1944392"/>
              </a:xfrm>
              <a:prstGeom prst="chord">
                <a:avLst>
                  <a:gd name="adj1" fmla="val 5381664"/>
                  <a:gd name="adj2" fmla="val 16200000"/>
                </a:avLst>
              </a:prstGeom>
              <a:solidFill>
                <a:schemeClr val="bg1">
                  <a:lumMod val="95000"/>
                </a:schemeClr>
              </a:solidFill>
              <a:ln w="6350">
                <a:solidFill>
                  <a:schemeClr val="accent4">
                    <a:lumMod val="60000"/>
                    <a:lumOff val="40000"/>
                  </a:schemeClr>
                </a:solidFill>
              </a:ln>
              <a:scene3d>
                <a:camera prst="orthographicFront"/>
                <a:lightRig rig="threePt" dir="t"/>
              </a:scene3d>
              <a:sp3d>
                <a:bevelT w="25400"/>
                <a:bevelB w="508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/>
              </a:p>
            </p:txBody>
          </p:sp>
          <p:grpSp>
            <p:nvGrpSpPr>
              <p:cNvPr id="27" name="Gruppieren 105"/>
              <p:cNvGrpSpPr>
                <a:grpSpLocks/>
              </p:cNvGrpSpPr>
              <p:nvPr/>
            </p:nvGrpSpPr>
            <p:grpSpPr bwMode="auto">
              <a:xfrm rot="-6281612">
                <a:off x="8524302" y="4871259"/>
                <a:ext cx="298450" cy="61912"/>
                <a:chOff x="1066800" y="762000"/>
                <a:chExt cx="1268918" cy="493301"/>
              </a:xfrm>
            </p:grpSpPr>
            <p:sp>
              <p:nvSpPr>
                <p:cNvPr id="170" name="Freihandform 169"/>
                <p:cNvSpPr/>
                <p:nvPr/>
              </p:nvSpPr>
              <p:spPr>
                <a:xfrm>
                  <a:off x="1075622" y="757206"/>
                  <a:ext cx="1181172" cy="455358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171" name="Freihandform 170"/>
                <p:cNvSpPr/>
                <p:nvPr/>
              </p:nvSpPr>
              <p:spPr>
                <a:xfrm rot="10586904">
                  <a:off x="1167026" y="802123"/>
                  <a:ext cx="1181172" cy="455358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72" name="Gerade Verbindung 171"/>
                <p:cNvCxnSpPr/>
                <p:nvPr/>
              </p:nvCxnSpPr>
              <p:spPr>
                <a:xfrm>
                  <a:off x="1223837" y="909878"/>
                  <a:ext cx="148490" cy="75893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3" name="Gerade Verbindung 172"/>
                <p:cNvCxnSpPr>
                  <a:stCxn id="171" idx="2"/>
                </p:cNvCxnSpPr>
                <p:nvPr/>
              </p:nvCxnSpPr>
              <p:spPr>
                <a:xfrm rot="10800000" flipV="1">
                  <a:off x="1607056" y="811463"/>
                  <a:ext cx="33746" cy="252977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4" name="Gerade Verbindung 173"/>
                <p:cNvCxnSpPr/>
                <p:nvPr/>
              </p:nvCxnSpPr>
              <p:spPr>
                <a:xfrm rot="16200000" flipH="1">
                  <a:off x="1642218" y="1015963"/>
                  <a:ext cx="227679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5" name="Gerade Verbindung 174"/>
                <p:cNvCxnSpPr>
                  <a:endCxn id="171" idx="1"/>
                </p:cNvCxnSpPr>
                <p:nvPr/>
              </p:nvCxnSpPr>
              <p:spPr>
                <a:xfrm rot="5400000">
                  <a:off x="1946123" y="1059516"/>
                  <a:ext cx="303572" cy="13499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8" name="Akkord 27"/>
              <p:cNvSpPr/>
              <p:nvPr/>
            </p:nvSpPr>
            <p:spPr bwMode="auto">
              <a:xfrm>
                <a:off x="8484788" y="3337024"/>
                <a:ext cx="891630" cy="1908000"/>
              </a:xfrm>
              <a:prstGeom prst="chord">
                <a:avLst>
                  <a:gd name="adj1" fmla="val 5416666"/>
                  <a:gd name="adj2" fmla="val 16178708"/>
                </a:avLst>
              </a:prstGeom>
              <a:gradFill flip="none" rotWithShape="1">
                <a:gsLst>
                  <a:gs pos="0">
                    <a:schemeClr val="bg1">
                      <a:lumMod val="95000"/>
                      <a:shade val="30000"/>
                      <a:satMod val="115000"/>
                    </a:schemeClr>
                  </a:gs>
                  <a:gs pos="50000">
                    <a:schemeClr val="bg1">
                      <a:lumMod val="95000"/>
                      <a:shade val="67500"/>
                      <a:satMod val="115000"/>
                    </a:schemeClr>
                  </a:gs>
                  <a:gs pos="100000">
                    <a:schemeClr val="bg1">
                      <a:lumMod val="95000"/>
                      <a:shade val="100000"/>
                      <a:satMod val="115000"/>
                    </a:schemeClr>
                  </a:gs>
                </a:gsLst>
                <a:lin ang="0" scaled="1"/>
                <a:tileRect/>
              </a:gradFill>
              <a:ln w="6350">
                <a:solidFill>
                  <a:schemeClr val="accent4">
                    <a:lumMod val="60000"/>
                    <a:lumOff val="40000"/>
                  </a:schemeClr>
                </a:solidFill>
              </a:ln>
              <a:effectLst>
                <a:outerShdw blurRad="50800" dist="38100" algn="l" rotWithShape="0">
                  <a:prstClr val="black">
                    <a:alpha val="40000"/>
                  </a:prstClr>
                </a:outerShdw>
              </a:effectLst>
              <a:scene3d>
                <a:camera prst="orthographicFront"/>
                <a:lightRig rig="threePt" dir="t"/>
              </a:scene3d>
              <a:sp3d contourW="12700">
                <a:bevelT w="25400"/>
                <a:bevelB w="4445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/>
              </a:p>
            </p:txBody>
          </p:sp>
          <p:grpSp>
            <p:nvGrpSpPr>
              <p:cNvPr id="29" name="Gruppieren 105"/>
              <p:cNvGrpSpPr>
                <a:grpSpLocks/>
              </p:cNvGrpSpPr>
              <p:nvPr/>
            </p:nvGrpSpPr>
            <p:grpSpPr bwMode="auto">
              <a:xfrm rot="-3692925">
                <a:off x="8245696" y="3981465"/>
                <a:ext cx="306387" cy="58737"/>
                <a:chOff x="1066800" y="762000"/>
                <a:chExt cx="1268918" cy="493301"/>
              </a:xfrm>
            </p:grpSpPr>
            <p:sp>
              <p:nvSpPr>
                <p:cNvPr id="164" name="Freihandform 163"/>
                <p:cNvSpPr/>
                <p:nvPr/>
              </p:nvSpPr>
              <p:spPr>
                <a:xfrm>
                  <a:off x="1066696" y="749287"/>
                  <a:ext cx="1176872" cy="453307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165" name="Freihandform 164"/>
                <p:cNvSpPr/>
                <p:nvPr/>
              </p:nvSpPr>
              <p:spPr>
                <a:xfrm rot="10586904">
                  <a:off x="1161600" y="796638"/>
                  <a:ext cx="1176876" cy="453307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66" name="Gerade Verbindung 165"/>
                <p:cNvCxnSpPr/>
                <p:nvPr/>
              </p:nvCxnSpPr>
              <p:spPr>
                <a:xfrm>
                  <a:off x="1220125" y="906250"/>
                  <a:ext cx="151221" cy="7999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7" name="Gerade Verbindung 166"/>
                <p:cNvCxnSpPr>
                  <a:stCxn id="165" idx="2"/>
                </p:cNvCxnSpPr>
                <p:nvPr/>
              </p:nvCxnSpPr>
              <p:spPr>
                <a:xfrm rot="10800000" flipV="1">
                  <a:off x="1598340" y="810214"/>
                  <a:ext cx="32876" cy="25331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8" name="Gerade Verbindung 167"/>
                <p:cNvCxnSpPr/>
                <p:nvPr/>
              </p:nvCxnSpPr>
              <p:spPr>
                <a:xfrm rot="16200000" flipH="1">
                  <a:off x="1640928" y="1007789"/>
                  <a:ext cx="226650" cy="6577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9" name="Gerade Verbindung 168"/>
                <p:cNvCxnSpPr>
                  <a:endCxn id="165" idx="1"/>
                </p:cNvCxnSpPr>
                <p:nvPr/>
              </p:nvCxnSpPr>
              <p:spPr>
                <a:xfrm rot="5400000">
                  <a:off x="1942977" y="1049962"/>
                  <a:ext cx="306653" cy="19722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30" name="Picture 3" descr="y:\Dokumente\Ergebnisse\Flureszenzmarkierte Partikel\Cell Subsets\Bild4.pn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8182" t="27118"/>
              <a:stretch>
                <a:fillRect/>
              </a:stretch>
            </p:blipFill>
            <p:spPr bwMode="auto">
              <a:xfrm>
                <a:off x="9793508" y="4624402"/>
                <a:ext cx="127000" cy="115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1" name="Picture 4" descr="y:\Dokumente\Ergebnisse\Flureszenzmarkierte Partikel\Cell Subsets\Bild4.pn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1818" b="18645"/>
              <a:stretch>
                <a:fillRect/>
              </a:stretch>
            </p:blipFill>
            <p:spPr bwMode="auto">
              <a:xfrm>
                <a:off x="9183908" y="3329002"/>
                <a:ext cx="177800" cy="1301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32" name="Gruppieren 105"/>
              <p:cNvGrpSpPr>
                <a:grpSpLocks/>
              </p:cNvGrpSpPr>
              <p:nvPr/>
            </p:nvGrpSpPr>
            <p:grpSpPr bwMode="auto">
              <a:xfrm rot="-9004258">
                <a:off x="8155208" y="4645040"/>
                <a:ext cx="306388" cy="60325"/>
                <a:chOff x="1066800" y="762000"/>
                <a:chExt cx="1268918" cy="493301"/>
              </a:xfrm>
            </p:grpSpPr>
            <p:sp>
              <p:nvSpPr>
                <p:cNvPr id="158" name="Freihandform 157"/>
                <p:cNvSpPr/>
                <p:nvPr/>
              </p:nvSpPr>
              <p:spPr>
                <a:xfrm>
                  <a:off x="1072853" y="774480"/>
                  <a:ext cx="1176872" cy="454360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159" name="Freihandform 158"/>
                <p:cNvSpPr/>
                <p:nvPr/>
              </p:nvSpPr>
              <p:spPr>
                <a:xfrm rot="10586904">
                  <a:off x="1168335" y="815739"/>
                  <a:ext cx="1176868" cy="454360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60" name="Gerade Verbindung 159"/>
                <p:cNvCxnSpPr/>
                <p:nvPr/>
              </p:nvCxnSpPr>
              <p:spPr>
                <a:xfrm>
                  <a:off x="1223525" y="917512"/>
                  <a:ext cx="151220" cy="7789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1" name="Gerade Verbindung 160"/>
                <p:cNvCxnSpPr>
                  <a:stCxn id="159" idx="2"/>
                </p:cNvCxnSpPr>
                <p:nvPr/>
              </p:nvCxnSpPr>
              <p:spPr>
                <a:xfrm rot="10800000" flipV="1">
                  <a:off x="1608076" y="830261"/>
                  <a:ext cx="32876" cy="24665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2" name="Gerade Verbindung 161"/>
                <p:cNvCxnSpPr/>
                <p:nvPr/>
              </p:nvCxnSpPr>
              <p:spPr>
                <a:xfrm rot="16200000" flipH="1">
                  <a:off x="1646428" y="1039625"/>
                  <a:ext cx="220683" cy="6577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3" name="Gerade Verbindung 162"/>
                <p:cNvCxnSpPr>
                  <a:endCxn id="159" idx="1"/>
                </p:cNvCxnSpPr>
                <p:nvPr/>
              </p:nvCxnSpPr>
              <p:spPr>
                <a:xfrm rot="5400000">
                  <a:off x="1953319" y="1074338"/>
                  <a:ext cx="298573" cy="19722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3" name="Gruppieren 38"/>
              <p:cNvGrpSpPr>
                <a:grpSpLocks/>
              </p:cNvGrpSpPr>
              <p:nvPr/>
            </p:nvGrpSpPr>
            <p:grpSpPr bwMode="auto">
              <a:xfrm rot="-5935535">
                <a:off x="8021065" y="3907645"/>
                <a:ext cx="298450" cy="61913"/>
                <a:chOff x="1066800" y="762000"/>
                <a:chExt cx="1268918" cy="493301"/>
              </a:xfrm>
            </p:grpSpPr>
            <p:sp>
              <p:nvSpPr>
                <p:cNvPr id="152" name="Freihandform 151"/>
                <p:cNvSpPr/>
                <p:nvPr/>
              </p:nvSpPr>
              <p:spPr>
                <a:xfrm>
                  <a:off x="1075564" y="751427"/>
                  <a:ext cx="1181176" cy="455351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153" name="Freihandform 152"/>
                <p:cNvSpPr/>
                <p:nvPr/>
              </p:nvSpPr>
              <p:spPr>
                <a:xfrm rot="10586904">
                  <a:off x="1167867" y="791401"/>
                  <a:ext cx="1181176" cy="455351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54" name="Gerade Verbindung 153"/>
                <p:cNvCxnSpPr/>
                <p:nvPr/>
              </p:nvCxnSpPr>
              <p:spPr>
                <a:xfrm>
                  <a:off x="1222227" y="909184"/>
                  <a:ext cx="148490" cy="75892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5" name="Gerade Verbindung 154"/>
                <p:cNvCxnSpPr>
                  <a:stCxn id="153" idx="2"/>
                </p:cNvCxnSpPr>
                <p:nvPr/>
              </p:nvCxnSpPr>
              <p:spPr>
                <a:xfrm rot="10800000" flipV="1">
                  <a:off x="1612414" y="803359"/>
                  <a:ext cx="33746" cy="252973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6" name="Gerade Verbindung 155"/>
                <p:cNvCxnSpPr/>
                <p:nvPr/>
              </p:nvCxnSpPr>
              <p:spPr>
                <a:xfrm rot="16200000" flipH="1">
                  <a:off x="1647952" y="1020058"/>
                  <a:ext cx="227676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7" name="Gerade Verbindung 156"/>
                <p:cNvCxnSpPr>
                  <a:endCxn id="153" idx="1"/>
                </p:cNvCxnSpPr>
                <p:nvPr/>
              </p:nvCxnSpPr>
              <p:spPr>
                <a:xfrm rot="5400000">
                  <a:off x="1941965" y="1046991"/>
                  <a:ext cx="303567" cy="13499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34" name="Picture 9" descr="y:\Dokumente\Ergebnisse\Flureszenzmarkierte Partikel\Cell Subsets\Bild4.pn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1818" b="18645"/>
              <a:stretch>
                <a:fillRect/>
              </a:stretch>
            </p:blipFill>
            <p:spPr bwMode="auto">
              <a:xfrm>
                <a:off x="8498108" y="3405202"/>
                <a:ext cx="177800" cy="1301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5" name="Picture 1" descr="y:\Dokumente\Ergebnisse\Flureszenzmarkierte Partikel\Cell Subsets\Bild4.png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4222625">
                <a:off x="7814690" y="4114021"/>
                <a:ext cx="349250" cy="1857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36" name="Gruppieren 105"/>
              <p:cNvGrpSpPr>
                <a:grpSpLocks/>
              </p:cNvGrpSpPr>
              <p:nvPr/>
            </p:nvGrpSpPr>
            <p:grpSpPr bwMode="auto">
              <a:xfrm rot="6970549">
                <a:off x="9777634" y="4284677"/>
                <a:ext cx="298450" cy="60325"/>
                <a:chOff x="1066800" y="762000"/>
                <a:chExt cx="1268918" cy="493301"/>
              </a:xfrm>
            </p:grpSpPr>
            <p:sp>
              <p:nvSpPr>
                <p:cNvPr id="146" name="Freihandform 145"/>
                <p:cNvSpPr/>
                <p:nvPr/>
              </p:nvSpPr>
              <p:spPr>
                <a:xfrm>
                  <a:off x="1069917" y="783851"/>
                  <a:ext cx="1181176" cy="454352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147" name="Freihandform 146"/>
                <p:cNvSpPr/>
                <p:nvPr/>
              </p:nvSpPr>
              <p:spPr>
                <a:xfrm rot="10586904">
                  <a:off x="1154310" y="819788"/>
                  <a:ext cx="1181176" cy="454352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48" name="Gerade Verbindung 147"/>
                <p:cNvCxnSpPr/>
                <p:nvPr/>
              </p:nvCxnSpPr>
              <p:spPr>
                <a:xfrm>
                  <a:off x="1216654" y="923706"/>
                  <a:ext cx="148490" cy="7789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9" name="Gerade Verbindung 148"/>
                <p:cNvCxnSpPr>
                  <a:stCxn id="147" idx="2"/>
                </p:cNvCxnSpPr>
                <p:nvPr/>
              </p:nvCxnSpPr>
              <p:spPr>
                <a:xfrm rot="10800000" flipV="1">
                  <a:off x="1601538" y="840709"/>
                  <a:ext cx="33746" cy="246646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0" name="Gerade Verbindung 149"/>
                <p:cNvCxnSpPr/>
                <p:nvPr/>
              </p:nvCxnSpPr>
              <p:spPr>
                <a:xfrm rot="16200000" flipH="1">
                  <a:off x="1646618" y="1050022"/>
                  <a:ext cx="220683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1" name="Gerade Verbindung 150"/>
                <p:cNvCxnSpPr>
                  <a:endCxn id="147" idx="1"/>
                </p:cNvCxnSpPr>
                <p:nvPr/>
              </p:nvCxnSpPr>
              <p:spPr>
                <a:xfrm rot="5400000">
                  <a:off x="1942575" y="1088288"/>
                  <a:ext cx="298573" cy="13499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7" name="Gruppieren 105"/>
              <p:cNvGrpSpPr>
                <a:grpSpLocks/>
              </p:cNvGrpSpPr>
              <p:nvPr/>
            </p:nvGrpSpPr>
            <p:grpSpPr bwMode="auto">
              <a:xfrm rot="-7489824">
                <a:off x="9525220" y="3594115"/>
                <a:ext cx="309563" cy="65088"/>
                <a:chOff x="1066800" y="762000"/>
                <a:chExt cx="1268918" cy="493301"/>
              </a:xfrm>
            </p:grpSpPr>
            <p:sp>
              <p:nvSpPr>
                <p:cNvPr id="140" name="Freihandform 139"/>
                <p:cNvSpPr/>
                <p:nvPr/>
              </p:nvSpPr>
              <p:spPr>
                <a:xfrm>
                  <a:off x="1071014" y="763512"/>
                  <a:ext cx="1177812" cy="457202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141" name="Freihandform 140"/>
                <p:cNvSpPr/>
                <p:nvPr/>
              </p:nvSpPr>
              <p:spPr>
                <a:xfrm rot="10586904">
                  <a:off x="1162751" y="793595"/>
                  <a:ext cx="1177816" cy="457202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42" name="Gerade Verbindung 141"/>
                <p:cNvCxnSpPr/>
                <p:nvPr/>
              </p:nvCxnSpPr>
              <p:spPr>
                <a:xfrm>
                  <a:off x="1214990" y="909150"/>
                  <a:ext cx="156174" cy="7219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3" name="Gerade Verbindung 142"/>
                <p:cNvCxnSpPr>
                  <a:stCxn id="141" idx="2"/>
                </p:cNvCxnSpPr>
                <p:nvPr/>
              </p:nvCxnSpPr>
              <p:spPr>
                <a:xfrm rot="10800000" flipV="1">
                  <a:off x="1602778" y="805863"/>
                  <a:ext cx="32534" cy="25266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4" name="Gerade Verbindung 143"/>
                <p:cNvCxnSpPr/>
                <p:nvPr/>
              </p:nvCxnSpPr>
              <p:spPr>
                <a:xfrm rot="16200000" flipH="1">
                  <a:off x="1648715" y="1025810"/>
                  <a:ext cx="216570" cy="650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5" name="Gerade Verbindung 144"/>
                <p:cNvCxnSpPr>
                  <a:endCxn id="141" idx="1"/>
                </p:cNvCxnSpPr>
                <p:nvPr/>
              </p:nvCxnSpPr>
              <p:spPr>
                <a:xfrm rot="5400000">
                  <a:off x="1946509" y="1056762"/>
                  <a:ext cx="300787" cy="1301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" name="Gruppieren 105"/>
              <p:cNvGrpSpPr>
                <a:grpSpLocks/>
              </p:cNvGrpSpPr>
              <p:nvPr/>
            </p:nvGrpSpPr>
            <p:grpSpPr bwMode="auto">
              <a:xfrm rot="9204393">
                <a:off x="9258521" y="5103827"/>
                <a:ext cx="309562" cy="63500"/>
                <a:chOff x="1066800" y="762000"/>
                <a:chExt cx="1268918" cy="493301"/>
              </a:xfrm>
            </p:grpSpPr>
            <p:sp>
              <p:nvSpPr>
                <p:cNvPr id="134" name="Freihandform 133"/>
                <p:cNvSpPr/>
                <p:nvPr/>
              </p:nvSpPr>
              <p:spPr>
                <a:xfrm>
                  <a:off x="1067241" y="785968"/>
                  <a:ext cx="1177820" cy="456307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135" name="Freihandform 134"/>
                <p:cNvSpPr/>
                <p:nvPr/>
              </p:nvSpPr>
              <p:spPr>
                <a:xfrm rot="10586904">
                  <a:off x="1160357" y="819147"/>
                  <a:ext cx="1177820" cy="456307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36" name="Gerade Verbindung 135"/>
                <p:cNvCxnSpPr/>
                <p:nvPr/>
              </p:nvCxnSpPr>
              <p:spPr>
                <a:xfrm>
                  <a:off x="1208486" y="923732"/>
                  <a:ext cx="156175" cy="86324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Gerade Verbindung 136"/>
                <p:cNvCxnSpPr>
                  <a:stCxn id="135" idx="2"/>
                </p:cNvCxnSpPr>
                <p:nvPr/>
              </p:nvCxnSpPr>
              <p:spPr>
                <a:xfrm rot="10800000" flipV="1">
                  <a:off x="1602065" y="834959"/>
                  <a:ext cx="32534" cy="258979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Gerade Verbindung 137"/>
                <p:cNvCxnSpPr/>
                <p:nvPr/>
              </p:nvCxnSpPr>
              <p:spPr>
                <a:xfrm rot="16200000" flipH="1">
                  <a:off x="1642647" y="1027501"/>
                  <a:ext cx="221985" cy="6509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9" name="Gerade Verbindung 138"/>
                <p:cNvCxnSpPr>
                  <a:endCxn id="135" idx="1"/>
                </p:cNvCxnSpPr>
                <p:nvPr/>
              </p:nvCxnSpPr>
              <p:spPr>
                <a:xfrm rot="5400000">
                  <a:off x="1932682" y="1071445"/>
                  <a:ext cx="308309" cy="1301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9" name="Gruppieren 105"/>
              <p:cNvGrpSpPr>
                <a:grpSpLocks/>
              </p:cNvGrpSpPr>
              <p:nvPr/>
            </p:nvGrpSpPr>
            <p:grpSpPr bwMode="auto">
              <a:xfrm rot="-6417114">
                <a:off x="7960740" y="4749021"/>
                <a:ext cx="306387" cy="60325"/>
                <a:chOff x="1066800" y="762000"/>
                <a:chExt cx="1268918" cy="493301"/>
              </a:xfrm>
            </p:grpSpPr>
            <p:sp>
              <p:nvSpPr>
                <p:cNvPr id="128" name="Freihandform 127"/>
                <p:cNvSpPr/>
                <p:nvPr/>
              </p:nvSpPr>
              <p:spPr>
                <a:xfrm>
                  <a:off x="1074127" y="764966"/>
                  <a:ext cx="1176876" cy="454352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129" name="Freihandform 128"/>
                <p:cNvSpPr/>
                <p:nvPr/>
              </p:nvSpPr>
              <p:spPr>
                <a:xfrm rot="10586904">
                  <a:off x="1166008" y="793121"/>
                  <a:ext cx="1176876" cy="454352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30" name="Gerade Verbindung 129"/>
                <p:cNvCxnSpPr/>
                <p:nvPr/>
              </p:nvCxnSpPr>
              <p:spPr>
                <a:xfrm>
                  <a:off x="1221468" y="916450"/>
                  <a:ext cx="151221" cy="7789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1" name="Gerade Verbindung 130"/>
                <p:cNvCxnSpPr>
                  <a:stCxn id="129" idx="2"/>
                </p:cNvCxnSpPr>
                <p:nvPr/>
              </p:nvCxnSpPr>
              <p:spPr>
                <a:xfrm rot="10800000" flipV="1">
                  <a:off x="1605939" y="817494"/>
                  <a:ext cx="32876" cy="246646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Gerade Verbindung 131"/>
                <p:cNvCxnSpPr/>
                <p:nvPr/>
              </p:nvCxnSpPr>
              <p:spPr>
                <a:xfrm rot="16200000" flipH="1">
                  <a:off x="1650390" y="1020799"/>
                  <a:ext cx="220691" cy="6577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3" name="Gerade Verbindung 132"/>
                <p:cNvCxnSpPr>
                  <a:endCxn id="129" idx="1"/>
                </p:cNvCxnSpPr>
                <p:nvPr/>
              </p:nvCxnSpPr>
              <p:spPr>
                <a:xfrm rot="5400000">
                  <a:off x="1948906" y="1054467"/>
                  <a:ext cx="298573" cy="19722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0" name="Gruppieren 105"/>
              <p:cNvGrpSpPr>
                <a:grpSpLocks/>
              </p:cNvGrpSpPr>
              <p:nvPr/>
            </p:nvGrpSpPr>
            <p:grpSpPr bwMode="auto">
              <a:xfrm rot="-9004258">
                <a:off x="8340946" y="5078427"/>
                <a:ext cx="304800" cy="58738"/>
                <a:chOff x="1066800" y="762000"/>
                <a:chExt cx="1268918" cy="493301"/>
              </a:xfrm>
            </p:grpSpPr>
            <p:sp>
              <p:nvSpPr>
                <p:cNvPr id="122" name="Freihandform 121"/>
                <p:cNvSpPr/>
                <p:nvPr/>
              </p:nvSpPr>
              <p:spPr>
                <a:xfrm>
                  <a:off x="1066288" y="751709"/>
                  <a:ext cx="1176393" cy="453300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123" name="Freihandform 122"/>
                <p:cNvSpPr/>
                <p:nvPr/>
              </p:nvSpPr>
              <p:spPr>
                <a:xfrm rot="10586904">
                  <a:off x="1162268" y="794080"/>
                  <a:ext cx="1176393" cy="453300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24" name="Gerade Verbindung 123"/>
                <p:cNvCxnSpPr/>
                <p:nvPr/>
              </p:nvCxnSpPr>
              <p:spPr>
                <a:xfrm>
                  <a:off x="1227982" y="899295"/>
                  <a:ext cx="152004" cy="79994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" name="Gerade Verbindung 124"/>
                <p:cNvCxnSpPr>
                  <a:stCxn id="123" idx="2"/>
                </p:cNvCxnSpPr>
                <p:nvPr/>
              </p:nvCxnSpPr>
              <p:spPr>
                <a:xfrm rot="10800000" flipV="1">
                  <a:off x="1614535" y="809687"/>
                  <a:ext cx="33043" cy="25331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" name="Gerade Verbindung 125"/>
                <p:cNvCxnSpPr/>
                <p:nvPr/>
              </p:nvCxnSpPr>
              <p:spPr>
                <a:xfrm rot="16200000" flipH="1">
                  <a:off x="1644519" y="1019852"/>
                  <a:ext cx="226646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" name="Gerade Verbindung 126"/>
                <p:cNvCxnSpPr>
                  <a:endCxn id="123" idx="1"/>
                </p:cNvCxnSpPr>
                <p:nvPr/>
              </p:nvCxnSpPr>
              <p:spPr>
                <a:xfrm rot="5400000">
                  <a:off x="1952157" y="1055652"/>
                  <a:ext cx="306640" cy="1321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41" name="Picture 1" descr="y:\Dokumente\Ergebnisse\Flureszenzmarkierte Partikel\Cell Subsets\Bild4.png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128" t="28465" r="35185" b="25146"/>
              <a:stretch>
                <a:fillRect/>
              </a:stretch>
            </p:blipFill>
            <p:spPr bwMode="auto">
              <a:xfrm rot="4541284">
                <a:off x="8413177" y="4733146"/>
                <a:ext cx="134937" cy="857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42" name="Gruppieren 105"/>
              <p:cNvGrpSpPr>
                <a:grpSpLocks/>
              </p:cNvGrpSpPr>
              <p:nvPr/>
            </p:nvGrpSpPr>
            <p:grpSpPr bwMode="auto">
              <a:xfrm rot="8372638">
                <a:off x="8099646" y="4335477"/>
                <a:ext cx="306387" cy="60325"/>
                <a:chOff x="1066800" y="762000"/>
                <a:chExt cx="1268918" cy="493301"/>
              </a:xfrm>
            </p:grpSpPr>
            <p:sp>
              <p:nvSpPr>
                <p:cNvPr id="116" name="Freihandform 115"/>
                <p:cNvSpPr/>
                <p:nvPr/>
              </p:nvSpPr>
              <p:spPr>
                <a:xfrm>
                  <a:off x="1068613" y="783806"/>
                  <a:ext cx="1176872" cy="454352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117" name="Freihandform 116"/>
                <p:cNvSpPr/>
                <p:nvPr/>
              </p:nvSpPr>
              <p:spPr>
                <a:xfrm rot="10586904">
                  <a:off x="1158508" y="815738"/>
                  <a:ext cx="1176872" cy="454360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18" name="Gerade Verbindung 117"/>
                <p:cNvCxnSpPr/>
                <p:nvPr/>
              </p:nvCxnSpPr>
              <p:spPr>
                <a:xfrm>
                  <a:off x="1218405" y="932319"/>
                  <a:ext cx="151216" cy="7789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9" name="Gerade Verbindung 118"/>
                <p:cNvCxnSpPr>
                  <a:stCxn id="117" idx="2"/>
                </p:cNvCxnSpPr>
                <p:nvPr/>
              </p:nvCxnSpPr>
              <p:spPr>
                <a:xfrm rot="10800000" flipV="1">
                  <a:off x="1596323" y="830146"/>
                  <a:ext cx="32876" cy="24665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Gerade Verbindung 119"/>
                <p:cNvCxnSpPr/>
                <p:nvPr/>
              </p:nvCxnSpPr>
              <p:spPr>
                <a:xfrm rot="16200000" flipH="1">
                  <a:off x="1641605" y="1048055"/>
                  <a:ext cx="220683" cy="6573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1" name="Gerade Verbindung 120"/>
                <p:cNvCxnSpPr>
                  <a:endCxn id="117" idx="1"/>
                </p:cNvCxnSpPr>
                <p:nvPr/>
              </p:nvCxnSpPr>
              <p:spPr>
                <a:xfrm rot="5400000">
                  <a:off x="1944286" y="1070747"/>
                  <a:ext cx="298581" cy="19722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3" name="Gruppieren 105"/>
              <p:cNvGrpSpPr>
                <a:grpSpLocks/>
              </p:cNvGrpSpPr>
              <p:nvPr/>
            </p:nvGrpSpPr>
            <p:grpSpPr bwMode="auto">
              <a:xfrm rot="-3977046">
                <a:off x="8205845" y="3604832"/>
                <a:ext cx="309886" cy="62702"/>
                <a:chOff x="1064832" y="759456"/>
                <a:chExt cx="1270243" cy="487106"/>
              </a:xfrm>
            </p:grpSpPr>
            <p:sp>
              <p:nvSpPr>
                <p:cNvPr id="110" name="Freihandform 109"/>
                <p:cNvSpPr/>
                <p:nvPr/>
              </p:nvSpPr>
              <p:spPr>
                <a:xfrm>
                  <a:off x="1064832" y="759456"/>
                  <a:ext cx="1177812" cy="456300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111" name="Freihandform 110"/>
                <p:cNvSpPr/>
                <p:nvPr/>
              </p:nvSpPr>
              <p:spPr>
                <a:xfrm rot="10586904">
                  <a:off x="1157263" y="790262"/>
                  <a:ext cx="1177812" cy="456300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12" name="Gerade Verbindung 111"/>
                <p:cNvCxnSpPr/>
                <p:nvPr/>
              </p:nvCxnSpPr>
              <p:spPr>
                <a:xfrm>
                  <a:off x="1206741" y="901362"/>
                  <a:ext cx="156174" cy="86332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Gerade Verbindung 112"/>
                <p:cNvCxnSpPr>
                  <a:stCxn id="111" idx="2"/>
                </p:cNvCxnSpPr>
                <p:nvPr/>
              </p:nvCxnSpPr>
              <p:spPr>
                <a:xfrm rot="10800000" flipV="1">
                  <a:off x="1603895" y="805252"/>
                  <a:ext cx="32538" cy="258979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Gerade Verbindung 113"/>
                <p:cNvCxnSpPr/>
                <p:nvPr/>
              </p:nvCxnSpPr>
              <p:spPr>
                <a:xfrm rot="16200000" flipH="1">
                  <a:off x="1642443" y="1015844"/>
                  <a:ext cx="221985" cy="6509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5" name="Gerade Verbindung 114"/>
                <p:cNvCxnSpPr>
                  <a:endCxn id="111" idx="1"/>
                </p:cNvCxnSpPr>
                <p:nvPr/>
              </p:nvCxnSpPr>
              <p:spPr>
                <a:xfrm rot="5400000">
                  <a:off x="1931863" y="1052242"/>
                  <a:ext cx="308309" cy="1301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4" name="Ellipse 43"/>
              <p:cNvSpPr/>
              <p:nvPr/>
            </p:nvSpPr>
            <p:spPr bwMode="auto">
              <a:xfrm>
                <a:off x="8580954" y="3881108"/>
                <a:ext cx="884112" cy="851903"/>
              </a:xfrm>
              <a:prstGeom prst="ellipse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>
                <a:outerShdw blurRad="50800" dist="38100" algn="l" rotWithShape="0">
                  <a:prstClr val="black">
                    <a:alpha val="40000"/>
                  </a:prstClr>
                </a:outerShdw>
              </a:effectLst>
              <a:scene3d>
                <a:camera prst="orthographicFront"/>
                <a:lightRig rig="threePt" dir="t"/>
              </a:scene3d>
              <a:sp3d>
                <a:bevelT w="1905000" h="1905000"/>
              </a:sp3d>
            </p:spPr>
            <p:style>
              <a:lnRef idx="1">
                <a:schemeClr val="accent6"/>
              </a:lnRef>
              <a:fillRef idx="2">
                <a:schemeClr val="accent6"/>
              </a:fillRef>
              <a:effectRef idx="1">
                <a:schemeClr val="accent6"/>
              </a:effectRef>
              <a:fontRef idx="minor">
                <a:schemeClr val="dk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/>
              </a:p>
            </p:txBody>
          </p:sp>
          <p:grpSp>
            <p:nvGrpSpPr>
              <p:cNvPr id="45" name="Gruppieren 105"/>
              <p:cNvGrpSpPr>
                <a:grpSpLocks/>
              </p:cNvGrpSpPr>
              <p:nvPr/>
            </p:nvGrpSpPr>
            <p:grpSpPr bwMode="auto">
              <a:xfrm rot="-7621007">
                <a:off x="8991027" y="4147358"/>
                <a:ext cx="300038" cy="60325"/>
                <a:chOff x="1066800" y="762000"/>
                <a:chExt cx="1268918" cy="493301"/>
              </a:xfrm>
            </p:grpSpPr>
            <p:sp>
              <p:nvSpPr>
                <p:cNvPr id="104" name="Freihandform 103"/>
                <p:cNvSpPr/>
                <p:nvPr/>
              </p:nvSpPr>
              <p:spPr>
                <a:xfrm>
                  <a:off x="1065490" y="756583"/>
                  <a:ext cx="1181636" cy="454360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105" name="Freihandform 104"/>
                <p:cNvSpPr/>
                <p:nvPr/>
              </p:nvSpPr>
              <p:spPr>
                <a:xfrm rot="10586904">
                  <a:off x="1154071" y="788178"/>
                  <a:ext cx="1181636" cy="454360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06" name="Gerade Verbindung 105"/>
                <p:cNvCxnSpPr/>
                <p:nvPr/>
              </p:nvCxnSpPr>
              <p:spPr>
                <a:xfrm>
                  <a:off x="1217939" y="909255"/>
                  <a:ext cx="147704" cy="7789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Gerade Verbindung 106"/>
                <p:cNvCxnSpPr>
                  <a:stCxn id="105" idx="2"/>
                </p:cNvCxnSpPr>
                <p:nvPr/>
              </p:nvCxnSpPr>
              <p:spPr>
                <a:xfrm rot="10800000" flipV="1">
                  <a:off x="1604680" y="809630"/>
                  <a:ext cx="33567" cy="24665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Gerade Verbindung 107"/>
                <p:cNvCxnSpPr/>
                <p:nvPr/>
              </p:nvCxnSpPr>
              <p:spPr>
                <a:xfrm rot="16200000" flipH="1">
                  <a:off x="1651987" y="1021169"/>
                  <a:ext cx="220691" cy="6716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Gerade Verbindung 108"/>
                <p:cNvCxnSpPr>
                  <a:endCxn id="105" idx="1"/>
                </p:cNvCxnSpPr>
                <p:nvPr/>
              </p:nvCxnSpPr>
              <p:spPr>
                <a:xfrm rot="5400000">
                  <a:off x="1944649" y="1062298"/>
                  <a:ext cx="298581" cy="1342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6" name="Gruppieren 105"/>
              <p:cNvGrpSpPr>
                <a:grpSpLocks/>
              </p:cNvGrpSpPr>
              <p:nvPr/>
            </p:nvGrpSpPr>
            <p:grpSpPr bwMode="auto">
              <a:xfrm rot="-9557810">
                <a:off x="8731471" y="4587890"/>
                <a:ext cx="298450" cy="61912"/>
                <a:chOff x="1066800" y="762000"/>
                <a:chExt cx="1268918" cy="493301"/>
              </a:xfrm>
            </p:grpSpPr>
            <p:sp>
              <p:nvSpPr>
                <p:cNvPr id="98" name="Freihandform 97"/>
                <p:cNvSpPr/>
                <p:nvPr/>
              </p:nvSpPr>
              <p:spPr>
                <a:xfrm>
                  <a:off x="1080225" y="755211"/>
                  <a:ext cx="1181172" cy="455358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99" name="Freihandform 98"/>
                <p:cNvSpPr/>
                <p:nvPr/>
              </p:nvSpPr>
              <p:spPr>
                <a:xfrm rot="10586904">
                  <a:off x="1166376" y="788843"/>
                  <a:ext cx="1181176" cy="455358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100" name="Gerade Verbindung 99"/>
                <p:cNvCxnSpPr/>
                <p:nvPr/>
              </p:nvCxnSpPr>
              <p:spPr>
                <a:xfrm>
                  <a:off x="1225228" y="910456"/>
                  <a:ext cx="148490" cy="75893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Gerade Verbindung 100"/>
                <p:cNvCxnSpPr>
                  <a:stCxn id="99" idx="2"/>
                </p:cNvCxnSpPr>
                <p:nvPr/>
              </p:nvCxnSpPr>
              <p:spPr>
                <a:xfrm rot="10800000" flipV="1">
                  <a:off x="1608053" y="807768"/>
                  <a:ext cx="33746" cy="252977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Gerade Verbindung 101"/>
                <p:cNvCxnSpPr/>
                <p:nvPr/>
              </p:nvCxnSpPr>
              <p:spPr>
                <a:xfrm rot="16200000" flipH="1">
                  <a:off x="1646282" y="1014286"/>
                  <a:ext cx="227679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Gerade Verbindung 102"/>
                <p:cNvCxnSpPr>
                  <a:endCxn id="99" idx="1"/>
                </p:cNvCxnSpPr>
                <p:nvPr/>
              </p:nvCxnSpPr>
              <p:spPr>
                <a:xfrm rot="5400000">
                  <a:off x="1942559" y="1054793"/>
                  <a:ext cx="303572" cy="13499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7" name="Gruppieren 216"/>
              <p:cNvGrpSpPr>
                <a:grpSpLocks/>
              </p:cNvGrpSpPr>
              <p:nvPr/>
            </p:nvGrpSpPr>
            <p:grpSpPr bwMode="auto">
              <a:xfrm rot="-2492098">
                <a:off x="8666383" y="4092590"/>
                <a:ext cx="360363" cy="125412"/>
                <a:chOff x="1524000" y="914400"/>
                <a:chExt cx="2133600" cy="609600"/>
              </a:xfrm>
            </p:grpSpPr>
            <p:sp>
              <p:nvSpPr>
                <p:cNvPr id="91" name="Ellipse 90"/>
                <p:cNvSpPr/>
                <p:nvPr/>
              </p:nvSpPr>
              <p:spPr>
                <a:xfrm>
                  <a:off x="1821880" y="912262"/>
                  <a:ext cx="310168" cy="308659"/>
                </a:xfrm>
                <a:prstGeom prst="ellipse">
                  <a:avLst/>
                </a:prstGeom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92" name="Ellipse 91"/>
                <p:cNvSpPr/>
                <p:nvPr/>
              </p:nvSpPr>
              <p:spPr>
                <a:xfrm>
                  <a:off x="2131536" y="988422"/>
                  <a:ext cx="300771" cy="300941"/>
                </a:xfrm>
                <a:prstGeom prst="ellipse">
                  <a:avLst/>
                </a:prstGeom>
              </p:spPr>
              <p:style>
                <a:lnRef idx="1">
                  <a:schemeClr val="accent2"/>
                </a:lnRef>
                <a:fillRef idx="3">
                  <a:schemeClr val="accent2"/>
                </a:fillRef>
                <a:effectRef idx="2">
                  <a:schemeClr val="accent2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93" name="Ellipse 92"/>
                <p:cNvSpPr/>
                <p:nvPr/>
              </p:nvSpPr>
              <p:spPr>
                <a:xfrm>
                  <a:off x="2434304" y="1139860"/>
                  <a:ext cx="310168" cy="300945"/>
                </a:xfrm>
                <a:prstGeom prst="ellipse">
                  <a:avLst/>
                </a:prstGeom>
              </p:spPr>
              <p:style>
                <a:lnRef idx="1">
                  <a:schemeClr val="dk1"/>
                </a:lnRef>
                <a:fillRef idx="3">
                  <a:schemeClr val="dk1"/>
                </a:fillRef>
                <a:effectRef idx="2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94" name="Ellipse 93"/>
                <p:cNvSpPr/>
                <p:nvPr/>
              </p:nvSpPr>
              <p:spPr>
                <a:xfrm>
                  <a:off x="2747881" y="1220168"/>
                  <a:ext cx="300771" cy="300945"/>
                </a:xfrm>
                <a:prstGeom prst="ellipse">
                  <a:avLst/>
                </a:prstGeom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95" name="Ellipse 94"/>
                <p:cNvSpPr/>
                <p:nvPr/>
              </p:nvSpPr>
              <p:spPr>
                <a:xfrm>
                  <a:off x="1525831" y="991197"/>
                  <a:ext cx="300771" cy="300945"/>
                </a:xfrm>
                <a:prstGeom prst="ellipse">
                  <a:avLst/>
                </a:prstGeom>
              </p:spPr>
              <p:style>
                <a:lnRef idx="1">
                  <a:schemeClr val="accent6"/>
                </a:lnRef>
                <a:fillRef idx="3">
                  <a:schemeClr val="accent6"/>
                </a:fillRef>
                <a:effectRef idx="2">
                  <a:schemeClr val="accent6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96" name="Ellipse 95"/>
                <p:cNvSpPr/>
                <p:nvPr/>
              </p:nvSpPr>
              <p:spPr>
                <a:xfrm>
                  <a:off x="3047041" y="1142201"/>
                  <a:ext cx="310173" cy="300941"/>
                </a:xfrm>
                <a:prstGeom prst="ellipse">
                  <a:avLst/>
                </a:prstGeom>
              </p:spPr>
              <p:style>
                <a:lnRef idx="1">
                  <a:schemeClr val="accent3"/>
                </a:lnRef>
                <a:fillRef idx="3">
                  <a:schemeClr val="accent3"/>
                </a:fillRef>
                <a:effectRef idx="2">
                  <a:schemeClr val="accent3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97" name="Ellipse 96"/>
                <p:cNvSpPr/>
                <p:nvPr/>
              </p:nvSpPr>
              <p:spPr>
                <a:xfrm>
                  <a:off x="3355604" y="1064230"/>
                  <a:ext cx="300771" cy="300945"/>
                </a:xfrm>
                <a:prstGeom prst="ellipse">
                  <a:avLst/>
                </a:prstGeom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</p:grpSp>
          <p:grpSp>
            <p:nvGrpSpPr>
              <p:cNvPr id="48" name="Gruppieren 47"/>
              <p:cNvGrpSpPr>
                <a:grpSpLocks/>
              </p:cNvGrpSpPr>
              <p:nvPr/>
            </p:nvGrpSpPr>
            <p:grpSpPr bwMode="auto">
              <a:xfrm rot="-6024299">
                <a:off x="9120408" y="4264040"/>
                <a:ext cx="352425" cy="127000"/>
                <a:chOff x="1524000" y="914400"/>
                <a:chExt cx="2133600" cy="609600"/>
              </a:xfrm>
            </p:grpSpPr>
            <p:sp>
              <p:nvSpPr>
                <p:cNvPr id="84" name="Ellipse 83"/>
                <p:cNvSpPr/>
                <p:nvPr/>
              </p:nvSpPr>
              <p:spPr>
                <a:xfrm>
                  <a:off x="1847748" y="910580"/>
                  <a:ext cx="297938" cy="304800"/>
                </a:xfrm>
                <a:prstGeom prst="ellipse">
                  <a:avLst/>
                </a:prstGeom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85" name="Ellipse 84"/>
                <p:cNvSpPr/>
                <p:nvPr/>
              </p:nvSpPr>
              <p:spPr>
                <a:xfrm>
                  <a:off x="2133767" y="983912"/>
                  <a:ext cx="307546" cy="304800"/>
                </a:xfrm>
                <a:prstGeom prst="ellipse">
                  <a:avLst/>
                </a:prstGeom>
              </p:spPr>
              <p:style>
                <a:lnRef idx="1">
                  <a:schemeClr val="accent2"/>
                </a:lnRef>
                <a:fillRef idx="3">
                  <a:schemeClr val="accent2"/>
                </a:fillRef>
                <a:effectRef idx="2">
                  <a:schemeClr val="accent2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86" name="Ellipse 85"/>
                <p:cNvSpPr/>
                <p:nvPr/>
              </p:nvSpPr>
              <p:spPr>
                <a:xfrm>
                  <a:off x="2440311" y="1137005"/>
                  <a:ext cx="307546" cy="304800"/>
                </a:xfrm>
                <a:prstGeom prst="ellipse">
                  <a:avLst/>
                </a:prstGeom>
              </p:spPr>
              <p:style>
                <a:lnRef idx="1">
                  <a:schemeClr val="dk1"/>
                </a:lnRef>
                <a:fillRef idx="3">
                  <a:schemeClr val="dk1"/>
                </a:fillRef>
                <a:effectRef idx="2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87" name="Ellipse 86"/>
                <p:cNvSpPr/>
                <p:nvPr/>
              </p:nvSpPr>
              <p:spPr>
                <a:xfrm>
                  <a:off x="2754762" y="1213775"/>
                  <a:ext cx="307546" cy="304800"/>
                </a:xfrm>
                <a:prstGeom prst="ellipse">
                  <a:avLst/>
                </a:prstGeom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88" name="Ellipse 87"/>
                <p:cNvSpPr/>
                <p:nvPr/>
              </p:nvSpPr>
              <p:spPr>
                <a:xfrm>
                  <a:off x="1526867" y="988524"/>
                  <a:ext cx="307546" cy="304800"/>
                </a:xfrm>
                <a:prstGeom prst="ellipse">
                  <a:avLst/>
                </a:prstGeom>
              </p:spPr>
              <p:style>
                <a:lnRef idx="1">
                  <a:schemeClr val="accent6"/>
                </a:lnRef>
                <a:fillRef idx="3">
                  <a:schemeClr val="accent6"/>
                </a:fillRef>
                <a:effectRef idx="2">
                  <a:schemeClr val="accent6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89" name="Ellipse 88"/>
                <p:cNvSpPr/>
                <p:nvPr/>
              </p:nvSpPr>
              <p:spPr>
                <a:xfrm>
                  <a:off x="3064457" y="1141952"/>
                  <a:ext cx="297938" cy="304800"/>
                </a:xfrm>
                <a:prstGeom prst="ellipse">
                  <a:avLst/>
                </a:prstGeom>
              </p:spPr>
              <p:style>
                <a:lnRef idx="1">
                  <a:schemeClr val="accent3"/>
                </a:lnRef>
                <a:fillRef idx="3">
                  <a:schemeClr val="accent3"/>
                </a:fillRef>
                <a:effectRef idx="2">
                  <a:schemeClr val="accent3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90" name="Ellipse 89"/>
                <p:cNvSpPr/>
                <p:nvPr/>
              </p:nvSpPr>
              <p:spPr>
                <a:xfrm>
                  <a:off x="3356830" y="1061261"/>
                  <a:ext cx="307546" cy="304800"/>
                </a:xfrm>
                <a:prstGeom prst="ellipse">
                  <a:avLst/>
                </a:prstGeom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</p:grpSp>
          <p:grpSp>
            <p:nvGrpSpPr>
              <p:cNvPr id="49" name="Gruppieren 216"/>
              <p:cNvGrpSpPr>
                <a:grpSpLocks/>
              </p:cNvGrpSpPr>
              <p:nvPr/>
            </p:nvGrpSpPr>
            <p:grpSpPr bwMode="auto">
              <a:xfrm rot="-350321">
                <a:off x="8807671" y="4422790"/>
                <a:ext cx="361950" cy="123825"/>
                <a:chOff x="1524000" y="914400"/>
                <a:chExt cx="2133600" cy="609600"/>
              </a:xfrm>
            </p:grpSpPr>
            <p:sp>
              <p:nvSpPr>
                <p:cNvPr id="77" name="Ellipse 76"/>
                <p:cNvSpPr/>
                <p:nvPr/>
              </p:nvSpPr>
              <p:spPr>
                <a:xfrm>
                  <a:off x="1830196" y="908572"/>
                  <a:ext cx="299453" cy="304798"/>
                </a:xfrm>
                <a:prstGeom prst="ellipse">
                  <a:avLst/>
                </a:prstGeom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78" name="Ellipse 77"/>
                <p:cNvSpPr/>
                <p:nvPr/>
              </p:nvSpPr>
              <p:spPr>
                <a:xfrm>
                  <a:off x="2130719" y="989627"/>
                  <a:ext cx="308808" cy="304802"/>
                </a:xfrm>
                <a:prstGeom prst="ellipse">
                  <a:avLst/>
                </a:prstGeom>
              </p:spPr>
              <p:style>
                <a:lnRef idx="1">
                  <a:schemeClr val="accent2"/>
                </a:lnRef>
                <a:fillRef idx="3">
                  <a:schemeClr val="accent2"/>
                </a:fillRef>
                <a:effectRef idx="2">
                  <a:schemeClr val="accent2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79" name="Ellipse 78"/>
                <p:cNvSpPr/>
                <p:nvPr/>
              </p:nvSpPr>
              <p:spPr>
                <a:xfrm>
                  <a:off x="2442289" y="1133681"/>
                  <a:ext cx="299453" cy="304798"/>
                </a:xfrm>
                <a:prstGeom prst="ellipse">
                  <a:avLst/>
                </a:prstGeom>
              </p:spPr>
              <p:style>
                <a:lnRef idx="1">
                  <a:schemeClr val="dk1"/>
                </a:lnRef>
                <a:fillRef idx="3">
                  <a:schemeClr val="dk1"/>
                </a:fillRef>
                <a:effectRef idx="2">
                  <a:schemeClr val="dk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80" name="Ellipse 79"/>
                <p:cNvSpPr/>
                <p:nvPr/>
              </p:nvSpPr>
              <p:spPr>
                <a:xfrm>
                  <a:off x="2733500" y="1213941"/>
                  <a:ext cx="308813" cy="304802"/>
                </a:xfrm>
                <a:prstGeom prst="ellipse">
                  <a:avLst/>
                </a:prstGeom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81" name="Ellipse 80"/>
                <p:cNvSpPr/>
                <p:nvPr/>
              </p:nvSpPr>
              <p:spPr>
                <a:xfrm>
                  <a:off x="1519897" y="984598"/>
                  <a:ext cx="308813" cy="304802"/>
                </a:xfrm>
                <a:prstGeom prst="ellipse">
                  <a:avLst/>
                </a:prstGeom>
              </p:spPr>
              <p:style>
                <a:lnRef idx="1">
                  <a:schemeClr val="accent6"/>
                </a:lnRef>
                <a:fillRef idx="3">
                  <a:schemeClr val="accent6"/>
                </a:fillRef>
                <a:effectRef idx="2">
                  <a:schemeClr val="accent6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82" name="Ellipse 81"/>
                <p:cNvSpPr/>
                <p:nvPr/>
              </p:nvSpPr>
              <p:spPr>
                <a:xfrm>
                  <a:off x="3043799" y="1137915"/>
                  <a:ext cx="299453" cy="304798"/>
                </a:xfrm>
                <a:prstGeom prst="ellipse">
                  <a:avLst/>
                </a:prstGeom>
              </p:spPr>
              <p:style>
                <a:lnRef idx="1">
                  <a:schemeClr val="accent3"/>
                </a:lnRef>
                <a:fillRef idx="3">
                  <a:schemeClr val="accent3"/>
                </a:fillRef>
                <a:effectRef idx="2">
                  <a:schemeClr val="accent3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83" name="Ellipse 82"/>
                <p:cNvSpPr/>
                <p:nvPr/>
              </p:nvSpPr>
              <p:spPr>
                <a:xfrm>
                  <a:off x="3343791" y="1069661"/>
                  <a:ext cx="308808" cy="304798"/>
                </a:xfrm>
                <a:prstGeom prst="ellipse">
                  <a:avLst/>
                </a:prstGeom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</p:grpSp>
          <p:grpSp>
            <p:nvGrpSpPr>
              <p:cNvPr id="50" name="Gruppieren 105"/>
              <p:cNvGrpSpPr>
                <a:grpSpLocks/>
              </p:cNvGrpSpPr>
              <p:nvPr/>
            </p:nvGrpSpPr>
            <p:grpSpPr bwMode="auto">
              <a:xfrm rot="-6275533">
                <a:off x="8490965" y="4341033"/>
                <a:ext cx="298450" cy="61913"/>
                <a:chOff x="1066800" y="762000"/>
                <a:chExt cx="1268918" cy="493301"/>
              </a:xfrm>
            </p:grpSpPr>
            <p:sp>
              <p:nvSpPr>
                <p:cNvPr id="71" name="Freihandform 70"/>
                <p:cNvSpPr/>
                <p:nvPr/>
              </p:nvSpPr>
              <p:spPr>
                <a:xfrm>
                  <a:off x="1075598" y="757326"/>
                  <a:ext cx="1181172" cy="455351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72" name="Freihandform 71"/>
                <p:cNvSpPr/>
                <p:nvPr/>
              </p:nvSpPr>
              <p:spPr>
                <a:xfrm rot="10586904">
                  <a:off x="1167043" y="801939"/>
                  <a:ext cx="1181172" cy="455351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73" name="Gerade Verbindung 72"/>
                <p:cNvCxnSpPr/>
                <p:nvPr/>
              </p:nvCxnSpPr>
              <p:spPr>
                <a:xfrm>
                  <a:off x="1223778" y="911215"/>
                  <a:ext cx="148490" cy="75892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Gerade Verbindung 73"/>
                <p:cNvCxnSpPr>
                  <a:stCxn id="72" idx="2"/>
                </p:cNvCxnSpPr>
                <p:nvPr/>
              </p:nvCxnSpPr>
              <p:spPr>
                <a:xfrm rot="10800000" flipV="1">
                  <a:off x="1606987" y="811722"/>
                  <a:ext cx="33746" cy="252973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Gerade Verbindung 74"/>
                <p:cNvCxnSpPr/>
                <p:nvPr/>
              </p:nvCxnSpPr>
              <p:spPr>
                <a:xfrm rot="16200000" flipH="1">
                  <a:off x="1642225" y="1015780"/>
                  <a:ext cx="227676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Gerade Verbindung 75"/>
                <p:cNvCxnSpPr>
                  <a:endCxn id="72" idx="1"/>
                </p:cNvCxnSpPr>
                <p:nvPr/>
              </p:nvCxnSpPr>
              <p:spPr>
                <a:xfrm rot="5400000">
                  <a:off x="1946178" y="1058199"/>
                  <a:ext cx="303567" cy="13499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51" name="Picture 2" descr="y:\Dokumente\Ergebnisse\Flureszenzmarkierte Partikel\Cell Subsets\Bild4.png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9697" b="16383"/>
              <a:stretch>
                <a:fillRect/>
              </a:stretch>
            </p:blipFill>
            <p:spPr bwMode="auto">
              <a:xfrm>
                <a:off x="8714008" y="4011627"/>
                <a:ext cx="184150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52" name="Picture 5" descr="y:\Dokumente\Ergebnisse\Flureszenzmarkierte Partikel\Cell Subsets\Bild4.png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284" t="9213"/>
              <a:stretch>
                <a:fillRect/>
              </a:stretch>
            </p:blipFill>
            <p:spPr bwMode="auto">
              <a:xfrm rot="15401881">
                <a:off x="9718896" y="3817952"/>
                <a:ext cx="184150" cy="149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53" name="Picture 7" descr="y:\Dokumente\Ergebnisse\Flureszenzmarkierte Partikel\Cell Subsets\Bild4.pn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0262"/>
              <a:stretch>
                <a:fillRect/>
              </a:stretch>
            </p:blipFill>
            <p:spPr bwMode="auto">
              <a:xfrm rot="20107108">
                <a:off x="9464896" y="4914915"/>
                <a:ext cx="304800" cy="635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54" name="Picture 8" descr="y:\Dokumente\Ergebnisse\Flureszenzmarkierte Partikel\Cell Subsets\Bild5.pn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97" t="63007"/>
              <a:stretch>
                <a:fillRect/>
              </a:stretch>
            </p:blipFill>
            <p:spPr bwMode="auto">
              <a:xfrm rot="15717846">
                <a:off x="8925940" y="4215620"/>
                <a:ext cx="158750" cy="1571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55" name="Picture 10" descr="y:\Dokumente\Ergebnisse\Flureszenzmarkierte Partikel\Cell Subsets\Bild5.png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309" t="23836" r="23225" b="18491"/>
              <a:stretch>
                <a:fillRect/>
              </a:stretch>
            </p:blipFill>
            <p:spPr bwMode="auto">
              <a:xfrm rot="1426321">
                <a:off x="9158508" y="3935427"/>
                <a:ext cx="106363" cy="238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56" name="Gruppieren 105"/>
              <p:cNvGrpSpPr>
                <a:grpSpLocks/>
              </p:cNvGrpSpPr>
              <p:nvPr/>
            </p:nvGrpSpPr>
            <p:grpSpPr bwMode="auto">
              <a:xfrm rot="-9032880">
                <a:off x="8798146" y="4238640"/>
                <a:ext cx="306387" cy="60325"/>
                <a:chOff x="1066800" y="762000"/>
                <a:chExt cx="1268918" cy="493301"/>
              </a:xfrm>
            </p:grpSpPr>
            <p:sp>
              <p:nvSpPr>
                <p:cNvPr id="65" name="Freihandform 64"/>
                <p:cNvSpPr/>
                <p:nvPr/>
              </p:nvSpPr>
              <p:spPr>
                <a:xfrm>
                  <a:off x="1072884" y="773823"/>
                  <a:ext cx="1176872" cy="454360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66" name="Freihandform 65"/>
                <p:cNvSpPr/>
                <p:nvPr/>
              </p:nvSpPr>
              <p:spPr>
                <a:xfrm rot="10586904">
                  <a:off x="1168185" y="816650"/>
                  <a:ext cx="1176876" cy="454360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67" name="Gerade Verbindung 66"/>
                <p:cNvCxnSpPr/>
                <p:nvPr/>
              </p:nvCxnSpPr>
              <p:spPr>
                <a:xfrm>
                  <a:off x="1221266" y="928593"/>
                  <a:ext cx="151221" cy="7789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Gerade Verbindung 67"/>
                <p:cNvCxnSpPr>
                  <a:stCxn id="66" idx="2"/>
                </p:cNvCxnSpPr>
                <p:nvPr/>
              </p:nvCxnSpPr>
              <p:spPr>
                <a:xfrm rot="10800000" flipV="1">
                  <a:off x="1608312" y="829001"/>
                  <a:ext cx="32872" cy="24665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Gerade Verbindung 68"/>
                <p:cNvCxnSpPr/>
                <p:nvPr/>
              </p:nvCxnSpPr>
              <p:spPr>
                <a:xfrm rot="16200000" flipH="1">
                  <a:off x="1646281" y="1040544"/>
                  <a:ext cx="220683" cy="6573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Gerade Verbindung 69"/>
                <p:cNvCxnSpPr>
                  <a:endCxn id="66" idx="1"/>
                </p:cNvCxnSpPr>
                <p:nvPr/>
              </p:nvCxnSpPr>
              <p:spPr>
                <a:xfrm rot="5400000">
                  <a:off x="1949751" y="1069627"/>
                  <a:ext cx="298581" cy="19726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57" name="Picture 11" descr="y:\Dokumente\Ergebnisse\Flureszenzmarkierte Partikel\Cell Subsets\Bild4.png"/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1792" t="55826"/>
              <a:stretch>
                <a:fillRect/>
              </a:stretch>
            </p:blipFill>
            <p:spPr bwMode="auto">
              <a:xfrm rot="20556710">
                <a:off x="9063258" y="4567252"/>
                <a:ext cx="169863" cy="60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58" name="Gruppieren 105"/>
              <p:cNvGrpSpPr>
                <a:grpSpLocks/>
              </p:cNvGrpSpPr>
              <p:nvPr/>
            </p:nvGrpSpPr>
            <p:grpSpPr bwMode="auto">
              <a:xfrm rot="-5798299">
                <a:off x="8998171" y="4464064"/>
                <a:ext cx="300038" cy="61913"/>
                <a:chOff x="1066800" y="762000"/>
                <a:chExt cx="1268918" cy="493301"/>
              </a:xfrm>
            </p:grpSpPr>
            <p:sp>
              <p:nvSpPr>
                <p:cNvPr id="59" name="Freihandform 58"/>
                <p:cNvSpPr/>
                <p:nvPr/>
              </p:nvSpPr>
              <p:spPr>
                <a:xfrm>
                  <a:off x="1061588" y="751157"/>
                  <a:ext cx="1181636" cy="455351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sp>
              <p:nvSpPr>
                <p:cNvPr id="60" name="Freihandform 59"/>
                <p:cNvSpPr/>
                <p:nvPr/>
              </p:nvSpPr>
              <p:spPr>
                <a:xfrm rot="10586904">
                  <a:off x="1153400" y="796755"/>
                  <a:ext cx="1181636" cy="455351"/>
                </a:xfrm>
                <a:custGeom>
                  <a:avLst/>
                  <a:gdLst>
                    <a:gd name="connsiteX0" fmla="*/ 0 w 1179689"/>
                    <a:gd name="connsiteY0" fmla="*/ 438385 h 457200"/>
                    <a:gd name="connsiteX1" fmla="*/ 259644 w 1179689"/>
                    <a:gd name="connsiteY1" fmla="*/ 20696 h 457200"/>
                    <a:gd name="connsiteX2" fmla="*/ 688622 w 1179689"/>
                    <a:gd name="connsiteY2" fmla="*/ 449674 h 457200"/>
                    <a:gd name="connsiteX3" fmla="*/ 1106311 w 1179689"/>
                    <a:gd name="connsiteY3" fmla="*/ 65852 h 457200"/>
                    <a:gd name="connsiteX4" fmla="*/ 1128889 w 1179689"/>
                    <a:gd name="connsiteY4" fmla="*/ 54563 h 457200"/>
                    <a:gd name="connsiteX5" fmla="*/ 1106311 w 1179689"/>
                    <a:gd name="connsiteY5" fmla="*/ 54563 h 457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79689" h="457200">
                      <a:moveTo>
                        <a:pt x="0" y="438385"/>
                      </a:moveTo>
                      <a:cubicBezTo>
                        <a:pt x="72437" y="228600"/>
                        <a:pt x="144874" y="18815"/>
                        <a:pt x="259644" y="20696"/>
                      </a:cubicBezTo>
                      <a:cubicBezTo>
                        <a:pt x="374414" y="22578"/>
                        <a:pt x="547511" y="442148"/>
                        <a:pt x="688622" y="449674"/>
                      </a:cubicBezTo>
                      <a:cubicBezTo>
                        <a:pt x="829733" y="457200"/>
                        <a:pt x="1032933" y="131704"/>
                        <a:pt x="1106311" y="65852"/>
                      </a:cubicBezTo>
                      <a:cubicBezTo>
                        <a:pt x="1179689" y="0"/>
                        <a:pt x="1128889" y="56444"/>
                        <a:pt x="1128889" y="54563"/>
                      </a:cubicBezTo>
                      <a:cubicBezTo>
                        <a:pt x="1128889" y="52682"/>
                        <a:pt x="1117600" y="53622"/>
                        <a:pt x="1106311" y="54563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de-DE" sz="1050"/>
                </a:p>
              </p:txBody>
            </p:sp>
            <p:cxnSp>
              <p:nvCxnSpPr>
                <p:cNvPr id="61" name="Gerade Verbindung 60"/>
                <p:cNvCxnSpPr/>
                <p:nvPr/>
              </p:nvCxnSpPr>
              <p:spPr>
                <a:xfrm>
                  <a:off x="1215330" y="912186"/>
                  <a:ext cx="147704" cy="75892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Gerade Verbindung 61"/>
                <p:cNvCxnSpPr>
                  <a:stCxn id="60" idx="2"/>
                </p:cNvCxnSpPr>
                <p:nvPr/>
              </p:nvCxnSpPr>
              <p:spPr>
                <a:xfrm rot="10800000" flipV="1">
                  <a:off x="1601269" y="806611"/>
                  <a:ext cx="33567" cy="252973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Gerade Verbindung 62"/>
                <p:cNvCxnSpPr/>
                <p:nvPr/>
              </p:nvCxnSpPr>
              <p:spPr>
                <a:xfrm rot="16200000" flipH="1">
                  <a:off x="1647051" y="1024734"/>
                  <a:ext cx="227676" cy="6712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Gerade Verbindung 63"/>
                <p:cNvCxnSpPr>
                  <a:endCxn id="60" idx="1"/>
                </p:cNvCxnSpPr>
                <p:nvPr/>
              </p:nvCxnSpPr>
              <p:spPr>
                <a:xfrm rot="5400000">
                  <a:off x="1941539" y="1056063"/>
                  <a:ext cx="303567" cy="1342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6" name="Textfeld 15"/>
            <p:cNvSpPr txBox="1"/>
            <p:nvPr/>
          </p:nvSpPr>
          <p:spPr>
            <a:xfrm>
              <a:off x="4326054" y="2107377"/>
              <a:ext cx="8470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chronically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 FV</a:t>
              </a:r>
            </a:p>
            <a:p>
              <a:r>
                <a:rPr lang="de-DE" sz="800" dirty="0" err="1">
                  <a:latin typeface="Arial" pitchFamily="34" charset="0"/>
                  <a:cs typeface="Arial" pitchFamily="34" charset="0"/>
                </a:rPr>
                <a:t>i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nfected</a:t>
              </a:r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 &gt; 6 </a:t>
              </a:r>
              <a:r>
                <a:rPr lang="de-DE" sz="800" dirty="0" err="1" smtClean="0">
                  <a:latin typeface="Arial" pitchFamily="34" charset="0"/>
                  <a:cs typeface="Arial" pitchFamily="34" charset="0"/>
                </a:rPr>
                <a:t>weeks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" name="Gerade Verbindung 16"/>
            <p:cNvCxnSpPr/>
            <p:nvPr/>
          </p:nvCxnSpPr>
          <p:spPr bwMode="auto">
            <a:xfrm rot="5400000">
              <a:off x="6051180" y="2120536"/>
              <a:ext cx="21694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feld 17"/>
            <p:cNvSpPr txBox="1"/>
            <p:nvPr/>
          </p:nvSpPr>
          <p:spPr bwMode="auto">
            <a:xfrm>
              <a:off x="6058978" y="1836090"/>
              <a:ext cx="24090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56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5559980" y="2211071"/>
              <a:ext cx="49564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 </a:t>
              </a:r>
              <a:r>
                <a:rPr lang="de-DE" sz="7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.p.v</a:t>
              </a:r>
              <a:r>
                <a:rPr lang="de-DE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de-DE" sz="10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5943523" y="2218765"/>
              <a:ext cx="5453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 </a:t>
              </a:r>
              <a:r>
                <a:rPr lang="de-DE" sz="7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.p.v</a:t>
              </a:r>
              <a:r>
                <a:rPr lang="de-DE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de-DE" sz="10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Ellipse 20"/>
            <p:cNvSpPr/>
            <p:nvPr/>
          </p:nvSpPr>
          <p:spPr>
            <a:xfrm>
              <a:off x="3936450" y="2125771"/>
              <a:ext cx="28901" cy="36000"/>
            </a:xfrm>
            <a:prstGeom prst="ellipse">
              <a:avLst/>
            </a:prstGeom>
            <a:solidFill>
              <a:schemeClr val="bg1"/>
            </a:solidFill>
            <a:ln w="31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22" name="Picture 333" descr="http://www.clker.com/cliparts/E/Q/D/S/6/T/mouse-hi.png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34216" y="1969834"/>
              <a:ext cx="535298" cy="52726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" name="Textfeld 22"/>
            <p:cNvSpPr txBox="1">
              <a:spLocks noChangeArrowheads="1"/>
            </p:cNvSpPr>
            <p:nvPr/>
          </p:nvSpPr>
          <p:spPr bwMode="auto">
            <a:xfrm>
              <a:off x="3914282" y="2437279"/>
              <a:ext cx="81939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SimSun" pitchFamily="2" charset="-122"/>
                </a:defRPr>
              </a:lvl9pPr>
            </a:lstStyle>
            <a:p>
              <a:pPr algn="ctr" eaLnBrk="1" hangingPunct="1"/>
              <a:r>
                <a:rPr lang="de-DE" sz="800" dirty="0" smtClean="0"/>
                <a:t>FV </a:t>
              </a:r>
              <a:r>
                <a:rPr lang="de-DE" sz="800" dirty="0" err="1" smtClean="0"/>
                <a:t>infection</a:t>
              </a:r>
              <a:endParaRPr lang="de-DE" sz="800" dirty="0"/>
            </a:p>
          </p:txBody>
        </p:sp>
      </p:grpSp>
      <p:sp>
        <p:nvSpPr>
          <p:cNvPr id="182" name="Textfeld 181"/>
          <p:cNvSpPr txBox="1"/>
          <p:nvPr/>
        </p:nvSpPr>
        <p:spPr>
          <a:xfrm>
            <a:off x="3428325" y="32352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graphicFrame>
        <p:nvGraphicFramePr>
          <p:cNvPr id="183" name="Objekt 18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6865690"/>
              </p:ext>
            </p:extLst>
          </p:nvPr>
        </p:nvGraphicFramePr>
        <p:xfrm>
          <a:off x="3365500" y="2054720"/>
          <a:ext cx="2262188" cy="1768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71" name="Prism 6" r:id="rId13" imgW="3476030" imgH="2813163" progId="Prism6.Document">
                  <p:embed/>
                </p:oleObj>
              </mc:Choice>
              <mc:Fallback>
                <p:oleObj name="Prism 6" r:id="rId13" imgW="3476030" imgH="2813163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65500" y="2054720"/>
                        <a:ext cx="2262188" cy="17684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" name="Objekt 18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6319656"/>
              </p:ext>
            </p:extLst>
          </p:nvPr>
        </p:nvGraphicFramePr>
        <p:xfrm>
          <a:off x="931863" y="3994336"/>
          <a:ext cx="2268537" cy="1736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72" name="Prism 6" r:id="rId15" imgW="3476030" imgH="2813163" progId="Prism6.Document">
                  <p:embed/>
                </p:oleObj>
              </mc:Choice>
              <mc:Fallback>
                <p:oleObj name="Prism 6" r:id="rId15" imgW="3476030" imgH="2813163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31863" y="3994336"/>
                        <a:ext cx="2268537" cy="17367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5" name="Textfeld 184"/>
          <p:cNvSpPr txBox="1"/>
          <p:nvPr/>
        </p:nvSpPr>
        <p:spPr>
          <a:xfrm>
            <a:off x="639318" y="191530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C</a:t>
            </a:r>
            <a:endParaRPr lang="de-DE" dirty="0"/>
          </a:p>
        </p:txBody>
      </p:sp>
      <p:graphicFrame>
        <p:nvGraphicFramePr>
          <p:cNvPr id="186" name="Objekt 18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5219690"/>
              </p:ext>
            </p:extLst>
          </p:nvPr>
        </p:nvGraphicFramePr>
        <p:xfrm>
          <a:off x="868197" y="2053802"/>
          <a:ext cx="2305050" cy="1782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73" name="Prism 6" r:id="rId17" imgW="3567504" imgH="2813163" progId="Prism6.Document">
                  <p:embed/>
                </p:oleObj>
              </mc:Choice>
              <mc:Fallback>
                <p:oleObj name="Prism 6" r:id="rId17" imgW="3567504" imgH="2813163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68197" y="2053802"/>
                        <a:ext cx="2305050" cy="17827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7" name="Textfeld 186"/>
          <p:cNvSpPr txBox="1"/>
          <p:nvPr/>
        </p:nvSpPr>
        <p:spPr>
          <a:xfrm>
            <a:off x="700011" y="370790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D</a:t>
            </a:r>
            <a:endParaRPr lang="de-DE" dirty="0"/>
          </a:p>
        </p:txBody>
      </p:sp>
      <p:sp>
        <p:nvSpPr>
          <p:cNvPr id="188" name="Textfeld 187"/>
          <p:cNvSpPr txBox="1"/>
          <p:nvPr/>
        </p:nvSpPr>
        <p:spPr>
          <a:xfrm>
            <a:off x="1688422" y="1994956"/>
            <a:ext cx="5245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.p.v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feld 188"/>
          <p:cNvSpPr txBox="1"/>
          <p:nvPr/>
        </p:nvSpPr>
        <p:spPr>
          <a:xfrm>
            <a:off x="2492896" y="1994956"/>
            <a:ext cx="5822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14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.p.v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feld 189"/>
          <p:cNvSpPr txBox="1"/>
          <p:nvPr/>
        </p:nvSpPr>
        <p:spPr>
          <a:xfrm>
            <a:off x="4163652" y="1994956"/>
            <a:ext cx="5245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.p.v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feld 190"/>
          <p:cNvSpPr txBox="1"/>
          <p:nvPr/>
        </p:nvSpPr>
        <p:spPr>
          <a:xfrm>
            <a:off x="5013176" y="1994956"/>
            <a:ext cx="5822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14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.p.v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feld 191"/>
          <p:cNvSpPr txBox="1"/>
          <p:nvPr/>
        </p:nvSpPr>
        <p:spPr>
          <a:xfrm>
            <a:off x="1688422" y="3935155"/>
            <a:ext cx="5245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.p.v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feld 192"/>
          <p:cNvSpPr txBox="1"/>
          <p:nvPr/>
        </p:nvSpPr>
        <p:spPr>
          <a:xfrm>
            <a:off x="2492896" y="3935155"/>
            <a:ext cx="5822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14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.p.v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4" name="Objekt 19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8074953"/>
              </p:ext>
            </p:extLst>
          </p:nvPr>
        </p:nvGraphicFramePr>
        <p:xfrm>
          <a:off x="3429000" y="3994336"/>
          <a:ext cx="2175361" cy="18850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74" name="Prism 6" r:id="rId19" imgW="3448660" imgH="2991439" progId="Prism6.Document">
                  <p:embed/>
                </p:oleObj>
              </mc:Choice>
              <mc:Fallback>
                <p:oleObj name="Prism 6" r:id="rId19" imgW="3448660" imgH="2991439" progId="Prism6.Document">
                  <p:embed/>
                  <p:pic>
                    <p:nvPicPr>
                      <p:cNvPr id="0" name="Objek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29000" y="3994336"/>
                        <a:ext cx="2175361" cy="188503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5" name="Textfeld 194"/>
          <p:cNvSpPr txBox="1"/>
          <p:nvPr/>
        </p:nvSpPr>
        <p:spPr>
          <a:xfrm>
            <a:off x="3893668" y="3935155"/>
            <a:ext cx="5245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.p.v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feld 195"/>
          <p:cNvSpPr txBox="1"/>
          <p:nvPr/>
        </p:nvSpPr>
        <p:spPr>
          <a:xfrm>
            <a:off x="4884281" y="3935155"/>
            <a:ext cx="5822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14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.p.v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7" name="Objekt 19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2456295"/>
              </p:ext>
            </p:extLst>
          </p:nvPr>
        </p:nvGraphicFramePr>
        <p:xfrm>
          <a:off x="785176" y="5868144"/>
          <a:ext cx="2373818" cy="17764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75" name="Prism 6" r:id="rId21" imgW="3695713" imgH="2764182" progId="Prism6.Document">
                  <p:embed/>
                </p:oleObj>
              </mc:Choice>
              <mc:Fallback>
                <p:oleObj name="Prism 6" r:id="rId21" imgW="3695713" imgH="2764182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85176" y="5868144"/>
                        <a:ext cx="2373818" cy="177649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0" name="Textfeld 199"/>
          <p:cNvSpPr txBox="1"/>
          <p:nvPr/>
        </p:nvSpPr>
        <p:spPr>
          <a:xfrm>
            <a:off x="696090" y="32352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grpSp>
        <p:nvGrpSpPr>
          <p:cNvPr id="201" name="Gruppieren 200"/>
          <p:cNvGrpSpPr/>
          <p:nvPr/>
        </p:nvGrpSpPr>
        <p:grpSpPr>
          <a:xfrm>
            <a:off x="1171377" y="798459"/>
            <a:ext cx="748849" cy="663706"/>
            <a:chOff x="7896407" y="3317269"/>
            <a:chExt cx="2083824" cy="1952121"/>
          </a:xfrm>
        </p:grpSpPr>
        <p:grpSp>
          <p:nvGrpSpPr>
            <p:cNvPr id="202" name="Gruppieren 105"/>
            <p:cNvGrpSpPr>
              <a:grpSpLocks/>
            </p:cNvGrpSpPr>
            <p:nvPr/>
          </p:nvGrpSpPr>
          <p:grpSpPr bwMode="auto">
            <a:xfrm rot="15318388">
              <a:off x="8413930" y="4978420"/>
              <a:ext cx="309564" cy="65087"/>
              <a:chOff x="1066800" y="762000"/>
              <a:chExt cx="1268918" cy="493301"/>
            </a:xfrm>
          </p:grpSpPr>
          <p:sp>
            <p:nvSpPr>
              <p:cNvPr id="354" name="Freihandform 353"/>
              <p:cNvSpPr/>
              <p:nvPr/>
            </p:nvSpPr>
            <p:spPr>
              <a:xfrm>
                <a:off x="1069118" y="752879"/>
                <a:ext cx="1177816" cy="457202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5" name="Freihandform 354"/>
              <p:cNvSpPr/>
              <p:nvPr/>
            </p:nvSpPr>
            <p:spPr>
              <a:xfrm rot="10586904">
                <a:off x="1163535" y="798651"/>
                <a:ext cx="1177812" cy="457202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56" name="Gerade Verbindung 355"/>
              <p:cNvCxnSpPr/>
              <p:nvPr/>
            </p:nvCxnSpPr>
            <p:spPr>
              <a:xfrm>
                <a:off x="1210791" y="915668"/>
                <a:ext cx="156174" cy="7219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7" name="Gerade Verbindung 356"/>
              <p:cNvCxnSpPr>
                <a:stCxn id="355" idx="2"/>
              </p:cNvCxnSpPr>
              <p:nvPr/>
            </p:nvCxnSpPr>
            <p:spPr>
              <a:xfrm rot="10800000" flipV="1">
                <a:off x="1601823" y="804685"/>
                <a:ext cx="32534" cy="252661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8" name="Gerade Verbindung 357"/>
              <p:cNvCxnSpPr/>
              <p:nvPr/>
            </p:nvCxnSpPr>
            <p:spPr>
              <a:xfrm rot="16200000" flipH="1">
                <a:off x="1645807" y="1012358"/>
                <a:ext cx="216570" cy="650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9" name="Gerade Verbindung 358"/>
              <p:cNvCxnSpPr>
                <a:endCxn id="355" idx="1"/>
              </p:cNvCxnSpPr>
              <p:nvPr/>
            </p:nvCxnSpPr>
            <p:spPr>
              <a:xfrm rot="5400000">
                <a:off x="1943542" y="1055710"/>
                <a:ext cx="300787" cy="1301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3" name="Ellipse 202"/>
            <p:cNvSpPr/>
            <p:nvPr/>
          </p:nvSpPr>
          <p:spPr bwMode="auto">
            <a:xfrm>
              <a:off x="7983454" y="3317269"/>
              <a:ext cx="1996777" cy="1951768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accent4">
                  <a:lumMod val="60000"/>
                  <a:lumOff val="4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 w="1905000" h="1905000"/>
            </a:sp3d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4" name="Akkord 203"/>
            <p:cNvSpPr/>
            <p:nvPr/>
          </p:nvSpPr>
          <p:spPr bwMode="auto">
            <a:xfrm flipH="1">
              <a:off x="8027825" y="3324995"/>
              <a:ext cx="1808403" cy="1944395"/>
            </a:xfrm>
            <a:prstGeom prst="chord">
              <a:avLst>
                <a:gd name="adj1" fmla="val 5381664"/>
                <a:gd name="adj2" fmla="val 16200000"/>
              </a:avLst>
            </a:prstGeom>
            <a:solidFill>
              <a:schemeClr val="bg1">
                <a:lumMod val="95000"/>
              </a:schemeClr>
            </a:solidFill>
            <a:ln w="6350">
              <a:solidFill>
                <a:schemeClr val="accent4">
                  <a:lumMod val="60000"/>
                  <a:lumOff val="4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 w="25400"/>
              <a:bevelB w="508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05" name="Gruppieren 105"/>
            <p:cNvGrpSpPr>
              <a:grpSpLocks/>
            </p:cNvGrpSpPr>
            <p:nvPr/>
          </p:nvGrpSpPr>
          <p:grpSpPr bwMode="auto">
            <a:xfrm rot="15318388">
              <a:off x="8524261" y="4871264"/>
              <a:ext cx="298451" cy="61911"/>
              <a:chOff x="1066800" y="762000"/>
              <a:chExt cx="1268918" cy="493301"/>
            </a:xfrm>
          </p:grpSpPr>
          <p:sp>
            <p:nvSpPr>
              <p:cNvPr id="348" name="Freihandform 347"/>
              <p:cNvSpPr/>
              <p:nvPr/>
            </p:nvSpPr>
            <p:spPr>
              <a:xfrm>
                <a:off x="1075622" y="757206"/>
                <a:ext cx="1181172" cy="455358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9" name="Freihandform 348"/>
              <p:cNvSpPr/>
              <p:nvPr/>
            </p:nvSpPr>
            <p:spPr>
              <a:xfrm rot="10586904">
                <a:off x="1167026" y="802123"/>
                <a:ext cx="1181172" cy="455358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50" name="Gerade Verbindung 349"/>
              <p:cNvCxnSpPr/>
              <p:nvPr/>
            </p:nvCxnSpPr>
            <p:spPr>
              <a:xfrm>
                <a:off x="1223837" y="909878"/>
                <a:ext cx="148490" cy="75893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1" name="Gerade Verbindung 350"/>
              <p:cNvCxnSpPr>
                <a:stCxn id="349" idx="2"/>
              </p:cNvCxnSpPr>
              <p:nvPr/>
            </p:nvCxnSpPr>
            <p:spPr>
              <a:xfrm rot="10800000" flipV="1">
                <a:off x="1607056" y="811463"/>
                <a:ext cx="33746" cy="25297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2" name="Gerade Verbindung 351"/>
              <p:cNvCxnSpPr/>
              <p:nvPr/>
            </p:nvCxnSpPr>
            <p:spPr>
              <a:xfrm rot="16200000" flipH="1">
                <a:off x="1642218" y="1015963"/>
                <a:ext cx="227679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3" name="Gerade Verbindung 352"/>
              <p:cNvCxnSpPr>
                <a:endCxn id="349" idx="1"/>
              </p:cNvCxnSpPr>
              <p:nvPr/>
            </p:nvCxnSpPr>
            <p:spPr>
              <a:xfrm rot="5400000">
                <a:off x="1946123" y="1059516"/>
                <a:ext cx="303572" cy="13499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6" name="Akkord 205"/>
            <p:cNvSpPr/>
            <p:nvPr/>
          </p:nvSpPr>
          <p:spPr bwMode="auto">
            <a:xfrm>
              <a:off x="8484749" y="3337028"/>
              <a:ext cx="891626" cy="1908002"/>
            </a:xfrm>
            <a:prstGeom prst="chord">
              <a:avLst>
                <a:gd name="adj1" fmla="val 5416666"/>
                <a:gd name="adj2" fmla="val 16178708"/>
              </a:avLst>
            </a:prstGeom>
            <a:gradFill flip="none" rotWithShape="1">
              <a:gsLst>
                <a:gs pos="0">
                  <a:schemeClr val="bg1">
                    <a:lumMod val="95000"/>
                    <a:shade val="30000"/>
                    <a:satMod val="115000"/>
                  </a:schemeClr>
                </a:gs>
                <a:gs pos="50000">
                  <a:schemeClr val="bg1">
                    <a:lumMod val="95000"/>
                    <a:shade val="67500"/>
                    <a:satMod val="115000"/>
                  </a:schemeClr>
                </a:gs>
                <a:gs pos="100000">
                  <a:schemeClr val="bg1">
                    <a:lumMod val="95000"/>
                    <a:shade val="100000"/>
                    <a:satMod val="115000"/>
                  </a:schemeClr>
                </a:gs>
              </a:gsLst>
              <a:lin ang="0" scaled="1"/>
              <a:tileRect/>
            </a:gradFill>
            <a:ln w="6350">
              <a:solidFill>
                <a:schemeClr val="accent4">
                  <a:lumMod val="60000"/>
                  <a:lumOff val="40000"/>
                </a:schemeClr>
              </a:solidFill>
            </a:ln>
            <a:effectLst>
              <a:outerShdw blurRad="50800" dist="38100" algn="l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 contourW="12700">
              <a:bevelT w="25400"/>
              <a:bevelB w="4445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07" name="Gruppieren 105"/>
            <p:cNvGrpSpPr>
              <a:grpSpLocks/>
            </p:cNvGrpSpPr>
            <p:nvPr/>
          </p:nvGrpSpPr>
          <p:grpSpPr bwMode="auto">
            <a:xfrm rot="17907075">
              <a:off x="8245657" y="3981470"/>
              <a:ext cx="306389" cy="58737"/>
              <a:chOff x="1066800" y="762000"/>
              <a:chExt cx="1268918" cy="493301"/>
            </a:xfrm>
          </p:grpSpPr>
          <p:sp>
            <p:nvSpPr>
              <p:cNvPr id="342" name="Freihandform 341"/>
              <p:cNvSpPr/>
              <p:nvPr/>
            </p:nvSpPr>
            <p:spPr>
              <a:xfrm>
                <a:off x="1066696" y="749287"/>
                <a:ext cx="1176872" cy="453307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3" name="Freihandform 342"/>
              <p:cNvSpPr/>
              <p:nvPr/>
            </p:nvSpPr>
            <p:spPr>
              <a:xfrm rot="10586904">
                <a:off x="1161600" y="796638"/>
                <a:ext cx="1176876" cy="453307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44" name="Gerade Verbindung 343"/>
              <p:cNvCxnSpPr/>
              <p:nvPr/>
            </p:nvCxnSpPr>
            <p:spPr>
              <a:xfrm>
                <a:off x="1220125" y="906250"/>
                <a:ext cx="151221" cy="7999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5" name="Gerade Verbindung 344"/>
              <p:cNvCxnSpPr>
                <a:stCxn id="343" idx="2"/>
              </p:cNvCxnSpPr>
              <p:nvPr/>
            </p:nvCxnSpPr>
            <p:spPr>
              <a:xfrm rot="10800000" flipV="1">
                <a:off x="1598340" y="810214"/>
                <a:ext cx="32876" cy="25331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6" name="Gerade Verbindung 345"/>
              <p:cNvCxnSpPr/>
              <p:nvPr/>
            </p:nvCxnSpPr>
            <p:spPr>
              <a:xfrm rot="16200000" flipH="1">
                <a:off x="1640928" y="1007789"/>
                <a:ext cx="226650" cy="657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7" name="Gerade Verbindung 346"/>
              <p:cNvCxnSpPr>
                <a:endCxn id="343" idx="1"/>
              </p:cNvCxnSpPr>
              <p:nvPr/>
            </p:nvCxnSpPr>
            <p:spPr>
              <a:xfrm rot="5400000">
                <a:off x="1942977" y="1049962"/>
                <a:ext cx="306653" cy="19722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08" name="Picture 3" descr="y:\Dokumente\Ergebnisse\Flureszenzmarkierte Partikel\Cell Subsets\Bild4.png"/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182" t="27118"/>
            <a:stretch>
              <a:fillRect/>
            </a:stretch>
          </p:blipFill>
          <p:spPr bwMode="auto">
            <a:xfrm>
              <a:off x="9793461" y="4624407"/>
              <a:ext cx="127000" cy="115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9" name="Picture 4" descr="y:\Dokumente\Ergebnisse\Flureszenzmarkierte Partikel\Cell Subsets\Bild4.png"/>
            <p:cNvPicPr>
              <a:picLocks noChangeAspect="1" noChangeArrowheads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1818" b="18645"/>
            <a:stretch>
              <a:fillRect/>
            </a:stretch>
          </p:blipFill>
          <p:spPr bwMode="auto">
            <a:xfrm>
              <a:off x="9183865" y="3329005"/>
              <a:ext cx="177800" cy="130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10" name="Gruppieren 105"/>
            <p:cNvGrpSpPr>
              <a:grpSpLocks/>
            </p:cNvGrpSpPr>
            <p:nvPr/>
          </p:nvGrpSpPr>
          <p:grpSpPr bwMode="auto">
            <a:xfrm rot="12595742">
              <a:off x="8155170" y="4645046"/>
              <a:ext cx="306387" cy="60324"/>
              <a:chOff x="1066800" y="762000"/>
              <a:chExt cx="1268918" cy="493301"/>
            </a:xfrm>
          </p:grpSpPr>
          <p:sp>
            <p:nvSpPr>
              <p:cNvPr id="336" name="Freihandform 335"/>
              <p:cNvSpPr/>
              <p:nvPr/>
            </p:nvSpPr>
            <p:spPr>
              <a:xfrm>
                <a:off x="1072853" y="774480"/>
                <a:ext cx="1176872" cy="454360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7" name="Freihandform 336"/>
              <p:cNvSpPr/>
              <p:nvPr/>
            </p:nvSpPr>
            <p:spPr>
              <a:xfrm rot="10586904">
                <a:off x="1168335" y="815739"/>
                <a:ext cx="1176868" cy="454360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38" name="Gerade Verbindung 337"/>
              <p:cNvCxnSpPr/>
              <p:nvPr/>
            </p:nvCxnSpPr>
            <p:spPr>
              <a:xfrm>
                <a:off x="1223525" y="917512"/>
                <a:ext cx="151220" cy="7789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9" name="Gerade Verbindung 338"/>
              <p:cNvCxnSpPr>
                <a:stCxn id="337" idx="2"/>
              </p:cNvCxnSpPr>
              <p:nvPr/>
            </p:nvCxnSpPr>
            <p:spPr>
              <a:xfrm rot="10800000" flipV="1">
                <a:off x="1608076" y="830261"/>
                <a:ext cx="32876" cy="24665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0" name="Gerade Verbindung 339"/>
              <p:cNvCxnSpPr/>
              <p:nvPr/>
            </p:nvCxnSpPr>
            <p:spPr>
              <a:xfrm rot="16200000" flipH="1">
                <a:off x="1646428" y="1039625"/>
                <a:ext cx="220683" cy="657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1" name="Gerade Verbindung 340"/>
              <p:cNvCxnSpPr>
                <a:endCxn id="337" idx="1"/>
              </p:cNvCxnSpPr>
              <p:nvPr/>
            </p:nvCxnSpPr>
            <p:spPr>
              <a:xfrm rot="5400000">
                <a:off x="1953319" y="1074338"/>
                <a:ext cx="298573" cy="19722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1" name="Gruppieren 210"/>
            <p:cNvGrpSpPr>
              <a:grpSpLocks/>
            </p:cNvGrpSpPr>
            <p:nvPr/>
          </p:nvGrpSpPr>
          <p:grpSpPr bwMode="auto">
            <a:xfrm rot="15664465">
              <a:off x="8021026" y="3907650"/>
              <a:ext cx="298451" cy="61913"/>
              <a:chOff x="1066800" y="762000"/>
              <a:chExt cx="1268918" cy="493301"/>
            </a:xfrm>
          </p:grpSpPr>
          <p:sp>
            <p:nvSpPr>
              <p:cNvPr id="330" name="Freihandform 329"/>
              <p:cNvSpPr/>
              <p:nvPr/>
            </p:nvSpPr>
            <p:spPr>
              <a:xfrm>
                <a:off x="1075564" y="751427"/>
                <a:ext cx="1181176" cy="455351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1" name="Freihandform 330"/>
              <p:cNvSpPr/>
              <p:nvPr/>
            </p:nvSpPr>
            <p:spPr>
              <a:xfrm rot="10586904">
                <a:off x="1167867" y="791401"/>
                <a:ext cx="1181176" cy="455351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32" name="Gerade Verbindung 331"/>
              <p:cNvCxnSpPr/>
              <p:nvPr/>
            </p:nvCxnSpPr>
            <p:spPr>
              <a:xfrm>
                <a:off x="1222227" y="909184"/>
                <a:ext cx="148490" cy="75892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3" name="Gerade Verbindung 332"/>
              <p:cNvCxnSpPr>
                <a:stCxn id="331" idx="2"/>
              </p:cNvCxnSpPr>
              <p:nvPr/>
            </p:nvCxnSpPr>
            <p:spPr>
              <a:xfrm rot="10800000" flipV="1">
                <a:off x="1612414" y="803359"/>
                <a:ext cx="33746" cy="252973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4" name="Gerade Verbindung 333"/>
              <p:cNvCxnSpPr/>
              <p:nvPr/>
            </p:nvCxnSpPr>
            <p:spPr>
              <a:xfrm rot="16200000" flipH="1">
                <a:off x="1647952" y="1020058"/>
                <a:ext cx="227676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5" name="Gerade Verbindung 334"/>
              <p:cNvCxnSpPr>
                <a:endCxn id="331" idx="1"/>
              </p:cNvCxnSpPr>
              <p:nvPr/>
            </p:nvCxnSpPr>
            <p:spPr>
              <a:xfrm rot="5400000">
                <a:off x="1941965" y="1046991"/>
                <a:ext cx="303567" cy="13499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12" name="Picture 9" descr="y:\Dokumente\Ergebnisse\Flureszenzmarkierte Partikel\Cell Subsets\Bild4.png"/>
            <p:cNvPicPr>
              <a:picLocks noChangeAspect="1" noChangeArrowheads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1818" b="18645"/>
            <a:stretch>
              <a:fillRect/>
            </a:stretch>
          </p:blipFill>
          <p:spPr bwMode="auto">
            <a:xfrm>
              <a:off x="8498069" y="3405205"/>
              <a:ext cx="177800" cy="130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13" name="Picture 1" descr="y:\Dokumente\Ergebnisse\Flureszenzmarkierte Partikel\Cell Subsets\Bild4.png"/>
            <p:cNvPicPr>
              <a:picLocks noChangeAspect="1" noChangeArrowheads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4222625">
              <a:off x="7814650" y="4114026"/>
              <a:ext cx="349251" cy="1857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14" name="Gruppieren 105"/>
            <p:cNvGrpSpPr>
              <a:grpSpLocks/>
            </p:cNvGrpSpPr>
            <p:nvPr/>
          </p:nvGrpSpPr>
          <p:grpSpPr bwMode="auto">
            <a:xfrm rot="6970549">
              <a:off x="9777588" y="4284682"/>
              <a:ext cx="298451" cy="60325"/>
              <a:chOff x="1066800" y="762000"/>
              <a:chExt cx="1268918" cy="493301"/>
            </a:xfrm>
          </p:grpSpPr>
          <p:sp>
            <p:nvSpPr>
              <p:cNvPr id="324" name="Freihandform 323"/>
              <p:cNvSpPr/>
              <p:nvPr/>
            </p:nvSpPr>
            <p:spPr>
              <a:xfrm>
                <a:off x="1069917" y="783851"/>
                <a:ext cx="1181176" cy="454352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5" name="Freihandform 324"/>
              <p:cNvSpPr/>
              <p:nvPr/>
            </p:nvSpPr>
            <p:spPr>
              <a:xfrm rot="10586904">
                <a:off x="1154310" y="819788"/>
                <a:ext cx="1181176" cy="454352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26" name="Gerade Verbindung 325"/>
              <p:cNvCxnSpPr/>
              <p:nvPr/>
            </p:nvCxnSpPr>
            <p:spPr>
              <a:xfrm>
                <a:off x="1216654" y="923706"/>
                <a:ext cx="148490" cy="7789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7" name="Gerade Verbindung 326"/>
              <p:cNvCxnSpPr>
                <a:stCxn id="325" idx="2"/>
              </p:cNvCxnSpPr>
              <p:nvPr/>
            </p:nvCxnSpPr>
            <p:spPr>
              <a:xfrm rot="10800000" flipV="1">
                <a:off x="1601538" y="840709"/>
                <a:ext cx="33746" cy="246646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8" name="Gerade Verbindung 327"/>
              <p:cNvCxnSpPr/>
              <p:nvPr/>
            </p:nvCxnSpPr>
            <p:spPr>
              <a:xfrm rot="16200000" flipH="1">
                <a:off x="1646618" y="1050022"/>
                <a:ext cx="220683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9" name="Gerade Verbindung 328"/>
              <p:cNvCxnSpPr>
                <a:endCxn id="325" idx="1"/>
              </p:cNvCxnSpPr>
              <p:nvPr/>
            </p:nvCxnSpPr>
            <p:spPr>
              <a:xfrm rot="5400000">
                <a:off x="1942575" y="1088288"/>
                <a:ext cx="298573" cy="13499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5" name="Gruppieren 105"/>
            <p:cNvGrpSpPr>
              <a:grpSpLocks/>
            </p:cNvGrpSpPr>
            <p:nvPr/>
          </p:nvGrpSpPr>
          <p:grpSpPr bwMode="auto">
            <a:xfrm rot="14110176">
              <a:off x="9525174" y="3594118"/>
              <a:ext cx="309564" cy="65087"/>
              <a:chOff x="1066800" y="762000"/>
              <a:chExt cx="1268918" cy="493301"/>
            </a:xfrm>
          </p:grpSpPr>
          <p:sp>
            <p:nvSpPr>
              <p:cNvPr id="318" name="Freihandform 317"/>
              <p:cNvSpPr/>
              <p:nvPr/>
            </p:nvSpPr>
            <p:spPr>
              <a:xfrm>
                <a:off x="1071014" y="763512"/>
                <a:ext cx="1177812" cy="457202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9" name="Freihandform 318"/>
              <p:cNvSpPr/>
              <p:nvPr/>
            </p:nvSpPr>
            <p:spPr>
              <a:xfrm rot="10586904">
                <a:off x="1162751" y="793595"/>
                <a:ext cx="1177816" cy="457202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20" name="Gerade Verbindung 319"/>
              <p:cNvCxnSpPr/>
              <p:nvPr/>
            </p:nvCxnSpPr>
            <p:spPr>
              <a:xfrm>
                <a:off x="1214990" y="909150"/>
                <a:ext cx="156174" cy="7219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1" name="Gerade Verbindung 320"/>
              <p:cNvCxnSpPr>
                <a:stCxn id="319" idx="2"/>
              </p:cNvCxnSpPr>
              <p:nvPr/>
            </p:nvCxnSpPr>
            <p:spPr>
              <a:xfrm rot="10800000" flipV="1">
                <a:off x="1602778" y="805863"/>
                <a:ext cx="32534" cy="252668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2" name="Gerade Verbindung 321"/>
              <p:cNvCxnSpPr/>
              <p:nvPr/>
            </p:nvCxnSpPr>
            <p:spPr>
              <a:xfrm rot="16200000" flipH="1">
                <a:off x="1648715" y="1025810"/>
                <a:ext cx="216570" cy="650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3" name="Gerade Verbindung 322"/>
              <p:cNvCxnSpPr>
                <a:endCxn id="319" idx="1"/>
              </p:cNvCxnSpPr>
              <p:nvPr/>
            </p:nvCxnSpPr>
            <p:spPr>
              <a:xfrm rot="5400000">
                <a:off x="1946509" y="1056762"/>
                <a:ext cx="300787" cy="1301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6" name="Gruppieren 105"/>
            <p:cNvGrpSpPr>
              <a:grpSpLocks/>
            </p:cNvGrpSpPr>
            <p:nvPr/>
          </p:nvGrpSpPr>
          <p:grpSpPr bwMode="auto">
            <a:xfrm rot="9204393">
              <a:off x="9258477" y="5103833"/>
              <a:ext cx="309561" cy="63499"/>
              <a:chOff x="1066800" y="762000"/>
              <a:chExt cx="1268918" cy="493301"/>
            </a:xfrm>
          </p:grpSpPr>
          <p:sp>
            <p:nvSpPr>
              <p:cNvPr id="312" name="Freihandform 311"/>
              <p:cNvSpPr/>
              <p:nvPr/>
            </p:nvSpPr>
            <p:spPr>
              <a:xfrm>
                <a:off x="1067241" y="785968"/>
                <a:ext cx="1177820" cy="456307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3" name="Freihandform 312"/>
              <p:cNvSpPr/>
              <p:nvPr/>
            </p:nvSpPr>
            <p:spPr>
              <a:xfrm rot="10586904">
                <a:off x="1160357" y="819147"/>
                <a:ext cx="1177820" cy="456307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14" name="Gerade Verbindung 313"/>
              <p:cNvCxnSpPr/>
              <p:nvPr/>
            </p:nvCxnSpPr>
            <p:spPr>
              <a:xfrm>
                <a:off x="1208486" y="923732"/>
                <a:ext cx="156175" cy="86324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5" name="Gerade Verbindung 314"/>
              <p:cNvCxnSpPr>
                <a:stCxn id="313" idx="2"/>
              </p:cNvCxnSpPr>
              <p:nvPr/>
            </p:nvCxnSpPr>
            <p:spPr>
              <a:xfrm rot="10800000" flipV="1">
                <a:off x="1602065" y="834959"/>
                <a:ext cx="32534" cy="258979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6" name="Gerade Verbindung 315"/>
              <p:cNvCxnSpPr/>
              <p:nvPr/>
            </p:nvCxnSpPr>
            <p:spPr>
              <a:xfrm rot="16200000" flipH="1">
                <a:off x="1642647" y="1027501"/>
                <a:ext cx="221985" cy="6509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7" name="Gerade Verbindung 316"/>
              <p:cNvCxnSpPr>
                <a:endCxn id="313" idx="1"/>
              </p:cNvCxnSpPr>
              <p:nvPr/>
            </p:nvCxnSpPr>
            <p:spPr>
              <a:xfrm rot="5400000">
                <a:off x="1932682" y="1071445"/>
                <a:ext cx="308309" cy="1301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7" name="Gruppieren 105"/>
            <p:cNvGrpSpPr>
              <a:grpSpLocks/>
            </p:cNvGrpSpPr>
            <p:nvPr/>
          </p:nvGrpSpPr>
          <p:grpSpPr bwMode="auto">
            <a:xfrm rot="15182886">
              <a:off x="7960705" y="4749028"/>
              <a:ext cx="306389" cy="60325"/>
              <a:chOff x="1066800" y="762000"/>
              <a:chExt cx="1268918" cy="493301"/>
            </a:xfrm>
          </p:grpSpPr>
          <p:sp>
            <p:nvSpPr>
              <p:cNvPr id="306" name="Freihandform 305"/>
              <p:cNvSpPr/>
              <p:nvPr/>
            </p:nvSpPr>
            <p:spPr>
              <a:xfrm>
                <a:off x="1074127" y="764966"/>
                <a:ext cx="1176876" cy="454352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7" name="Freihandform 306"/>
              <p:cNvSpPr/>
              <p:nvPr/>
            </p:nvSpPr>
            <p:spPr>
              <a:xfrm rot="10586904">
                <a:off x="1166008" y="793121"/>
                <a:ext cx="1176876" cy="454352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08" name="Gerade Verbindung 307"/>
              <p:cNvCxnSpPr/>
              <p:nvPr/>
            </p:nvCxnSpPr>
            <p:spPr>
              <a:xfrm>
                <a:off x="1221468" y="916450"/>
                <a:ext cx="151221" cy="7789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9" name="Gerade Verbindung 308"/>
              <p:cNvCxnSpPr>
                <a:stCxn id="307" idx="2"/>
              </p:cNvCxnSpPr>
              <p:nvPr/>
            </p:nvCxnSpPr>
            <p:spPr>
              <a:xfrm rot="10800000" flipV="1">
                <a:off x="1605939" y="817494"/>
                <a:ext cx="32876" cy="246646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0" name="Gerade Verbindung 309"/>
              <p:cNvCxnSpPr/>
              <p:nvPr/>
            </p:nvCxnSpPr>
            <p:spPr>
              <a:xfrm rot="16200000" flipH="1">
                <a:off x="1650390" y="1020799"/>
                <a:ext cx="220691" cy="657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1" name="Gerade Verbindung 310"/>
              <p:cNvCxnSpPr>
                <a:endCxn id="307" idx="1"/>
              </p:cNvCxnSpPr>
              <p:nvPr/>
            </p:nvCxnSpPr>
            <p:spPr>
              <a:xfrm rot="5400000">
                <a:off x="1948906" y="1054467"/>
                <a:ext cx="298573" cy="19722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8" name="Gruppieren 105"/>
            <p:cNvGrpSpPr>
              <a:grpSpLocks/>
            </p:cNvGrpSpPr>
            <p:nvPr/>
          </p:nvGrpSpPr>
          <p:grpSpPr bwMode="auto">
            <a:xfrm rot="12595742">
              <a:off x="8340911" y="5078434"/>
              <a:ext cx="304799" cy="58739"/>
              <a:chOff x="1066800" y="762000"/>
              <a:chExt cx="1268918" cy="493301"/>
            </a:xfrm>
          </p:grpSpPr>
          <p:sp>
            <p:nvSpPr>
              <p:cNvPr id="300" name="Freihandform 299"/>
              <p:cNvSpPr/>
              <p:nvPr/>
            </p:nvSpPr>
            <p:spPr>
              <a:xfrm>
                <a:off x="1066288" y="751709"/>
                <a:ext cx="1176393" cy="453300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1" name="Freihandform 300"/>
              <p:cNvSpPr/>
              <p:nvPr/>
            </p:nvSpPr>
            <p:spPr>
              <a:xfrm rot="10586904">
                <a:off x="1162268" y="794080"/>
                <a:ext cx="1176393" cy="453300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02" name="Gerade Verbindung 301"/>
              <p:cNvCxnSpPr/>
              <p:nvPr/>
            </p:nvCxnSpPr>
            <p:spPr>
              <a:xfrm>
                <a:off x="1227982" y="899295"/>
                <a:ext cx="152004" cy="79994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3" name="Gerade Verbindung 302"/>
              <p:cNvCxnSpPr>
                <a:stCxn id="301" idx="2"/>
              </p:cNvCxnSpPr>
              <p:nvPr/>
            </p:nvCxnSpPr>
            <p:spPr>
              <a:xfrm rot="10800000" flipV="1">
                <a:off x="1614535" y="809687"/>
                <a:ext cx="33043" cy="25331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4" name="Gerade Verbindung 303"/>
              <p:cNvCxnSpPr/>
              <p:nvPr/>
            </p:nvCxnSpPr>
            <p:spPr>
              <a:xfrm rot="16200000" flipH="1">
                <a:off x="1644519" y="1019852"/>
                <a:ext cx="226646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5" name="Gerade Verbindung 304"/>
              <p:cNvCxnSpPr>
                <a:endCxn id="301" idx="1"/>
              </p:cNvCxnSpPr>
              <p:nvPr/>
            </p:nvCxnSpPr>
            <p:spPr>
              <a:xfrm rot="5400000">
                <a:off x="1952157" y="1055652"/>
                <a:ext cx="306640" cy="13218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19" name="Picture 1" descr="y:\Dokumente\Ergebnisse\Flureszenzmarkierte Partikel\Cell Subsets\Bild4.png"/>
            <p:cNvPicPr>
              <a:picLocks noChangeAspect="1" noChangeArrowheads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28" t="28465" r="35185" b="25146"/>
            <a:stretch>
              <a:fillRect/>
            </a:stretch>
          </p:blipFill>
          <p:spPr bwMode="auto">
            <a:xfrm rot="4541284">
              <a:off x="8413141" y="4733154"/>
              <a:ext cx="134937" cy="857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20" name="Gruppieren 105"/>
            <p:cNvGrpSpPr>
              <a:grpSpLocks/>
            </p:cNvGrpSpPr>
            <p:nvPr/>
          </p:nvGrpSpPr>
          <p:grpSpPr bwMode="auto">
            <a:xfrm rot="8372638">
              <a:off x="8099610" y="4335483"/>
              <a:ext cx="306385" cy="60324"/>
              <a:chOff x="1066800" y="762000"/>
              <a:chExt cx="1268918" cy="493301"/>
            </a:xfrm>
          </p:grpSpPr>
          <p:sp>
            <p:nvSpPr>
              <p:cNvPr id="294" name="Freihandform 293"/>
              <p:cNvSpPr/>
              <p:nvPr/>
            </p:nvSpPr>
            <p:spPr>
              <a:xfrm>
                <a:off x="1068613" y="783806"/>
                <a:ext cx="1176872" cy="454352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5" name="Freihandform 294"/>
              <p:cNvSpPr/>
              <p:nvPr/>
            </p:nvSpPr>
            <p:spPr>
              <a:xfrm rot="10586904">
                <a:off x="1158508" y="815738"/>
                <a:ext cx="1176872" cy="454360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96" name="Gerade Verbindung 295"/>
              <p:cNvCxnSpPr/>
              <p:nvPr/>
            </p:nvCxnSpPr>
            <p:spPr>
              <a:xfrm>
                <a:off x="1218405" y="932319"/>
                <a:ext cx="151216" cy="7789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7" name="Gerade Verbindung 296"/>
              <p:cNvCxnSpPr>
                <a:stCxn id="295" idx="2"/>
              </p:cNvCxnSpPr>
              <p:nvPr/>
            </p:nvCxnSpPr>
            <p:spPr>
              <a:xfrm rot="10800000" flipV="1">
                <a:off x="1596323" y="830146"/>
                <a:ext cx="32876" cy="24665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8" name="Gerade Verbindung 297"/>
              <p:cNvCxnSpPr/>
              <p:nvPr/>
            </p:nvCxnSpPr>
            <p:spPr>
              <a:xfrm rot="16200000" flipH="1">
                <a:off x="1641605" y="1048055"/>
                <a:ext cx="220683" cy="6573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9" name="Gerade Verbindung 298"/>
              <p:cNvCxnSpPr>
                <a:endCxn id="295" idx="1"/>
              </p:cNvCxnSpPr>
              <p:nvPr/>
            </p:nvCxnSpPr>
            <p:spPr>
              <a:xfrm rot="5400000">
                <a:off x="1944286" y="1070747"/>
                <a:ext cx="298581" cy="19722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1" name="Gruppieren 105"/>
            <p:cNvGrpSpPr>
              <a:grpSpLocks/>
            </p:cNvGrpSpPr>
            <p:nvPr/>
          </p:nvGrpSpPr>
          <p:grpSpPr bwMode="auto">
            <a:xfrm rot="17622954">
              <a:off x="8205809" y="3604835"/>
              <a:ext cx="309886" cy="62702"/>
              <a:chOff x="1064832" y="759456"/>
              <a:chExt cx="1270243" cy="487106"/>
            </a:xfrm>
          </p:grpSpPr>
          <p:sp>
            <p:nvSpPr>
              <p:cNvPr id="288" name="Freihandform 287"/>
              <p:cNvSpPr/>
              <p:nvPr/>
            </p:nvSpPr>
            <p:spPr>
              <a:xfrm>
                <a:off x="1064832" y="759456"/>
                <a:ext cx="1177812" cy="456300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9" name="Freihandform 288"/>
              <p:cNvSpPr/>
              <p:nvPr/>
            </p:nvSpPr>
            <p:spPr>
              <a:xfrm rot="10586904">
                <a:off x="1157263" y="790262"/>
                <a:ext cx="1177812" cy="456300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90" name="Gerade Verbindung 289"/>
              <p:cNvCxnSpPr/>
              <p:nvPr/>
            </p:nvCxnSpPr>
            <p:spPr>
              <a:xfrm>
                <a:off x="1206741" y="901362"/>
                <a:ext cx="156174" cy="86332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1" name="Gerade Verbindung 290"/>
              <p:cNvCxnSpPr>
                <a:stCxn id="289" idx="2"/>
              </p:cNvCxnSpPr>
              <p:nvPr/>
            </p:nvCxnSpPr>
            <p:spPr>
              <a:xfrm rot="10800000" flipV="1">
                <a:off x="1603895" y="805252"/>
                <a:ext cx="32538" cy="258979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2" name="Gerade Verbindung 291"/>
              <p:cNvCxnSpPr/>
              <p:nvPr/>
            </p:nvCxnSpPr>
            <p:spPr>
              <a:xfrm rot="16200000" flipH="1">
                <a:off x="1642443" y="1015844"/>
                <a:ext cx="221985" cy="6509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3" name="Gerade Verbindung 292"/>
              <p:cNvCxnSpPr>
                <a:endCxn id="289" idx="1"/>
              </p:cNvCxnSpPr>
              <p:nvPr/>
            </p:nvCxnSpPr>
            <p:spPr>
              <a:xfrm rot="5400000">
                <a:off x="1931863" y="1052242"/>
                <a:ext cx="308309" cy="1301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2" name="Ellipse 221"/>
            <p:cNvSpPr/>
            <p:nvPr/>
          </p:nvSpPr>
          <p:spPr bwMode="auto">
            <a:xfrm>
              <a:off x="8580915" y="3881111"/>
              <a:ext cx="884108" cy="851904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  <a:effectLst>
              <a:outerShdw blurRad="50800" dist="38100" algn="l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 w="1905000" h="1905000"/>
            </a:sp3d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23" name="Gruppieren 105"/>
            <p:cNvGrpSpPr>
              <a:grpSpLocks/>
            </p:cNvGrpSpPr>
            <p:nvPr/>
          </p:nvGrpSpPr>
          <p:grpSpPr bwMode="auto">
            <a:xfrm rot="13978993">
              <a:off x="8990987" y="4147363"/>
              <a:ext cx="300038" cy="60325"/>
              <a:chOff x="1066800" y="762000"/>
              <a:chExt cx="1268918" cy="493301"/>
            </a:xfrm>
          </p:grpSpPr>
          <p:sp>
            <p:nvSpPr>
              <p:cNvPr id="282" name="Freihandform 281"/>
              <p:cNvSpPr/>
              <p:nvPr/>
            </p:nvSpPr>
            <p:spPr>
              <a:xfrm>
                <a:off x="1065490" y="756583"/>
                <a:ext cx="1181636" cy="454360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3" name="Freihandform 282"/>
              <p:cNvSpPr/>
              <p:nvPr/>
            </p:nvSpPr>
            <p:spPr>
              <a:xfrm rot="10586904">
                <a:off x="1154071" y="788178"/>
                <a:ext cx="1181636" cy="454360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84" name="Gerade Verbindung 283"/>
              <p:cNvCxnSpPr/>
              <p:nvPr/>
            </p:nvCxnSpPr>
            <p:spPr>
              <a:xfrm>
                <a:off x="1217939" y="909255"/>
                <a:ext cx="147704" cy="7789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5" name="Gerade Verbindung 284"/>
              <p:cNvCxnSpPr>
                <a:stCxn id="283" idx="2"/>
              </p:cNvCxnSpPr>
              <p:nvPr/>
            </p:nvCxnSpPr>
            <p:spPr>
              <a:xfrm rot="10800000" flipV="1">
                <a:off x="1604680" y="809630"/>
                <a:ext cx="33567" cy="24665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6" name="Gerade Verbindung 285"/>
              <p:cNvCxnSpPr/>
              <p:nvPr/>
            </p:nvCxnSpPr>
            <p:spPr>
              <a:xfrm rot="16200000" flipH="1">
                <a:off x="1651987" y="1021169"/>
                <a:ext cx="220691" cy="6716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7" name="Gerade Verbindung 286"/>
              <p:cNvCxnSpPr>
                <a:endCxn id="283" idx="1"/>
              </p:cNvCxnSpPr>
              <p:nvPr/>
            </p:nvCxnSpPr>
            <p:spPr>
              <a:xfrm rot="5400000">
                <a:off x="1944649" y="1062298"/>
                <a:ext cx="298581" cy="13428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4" name="Gruppieren 105"/>
            <p:cNvGrpSpPr>
              <a:grpSpLocks/>
            </p:cNvGrpSpPr>
            <p:nvPr/>
          </p:nvGrpSpPr>
          <p:grpSpPr bwMode="auto">
            <a:xfrm rot="12042190">
              <a:off x="8731432" y="4587894"/>
              <a:ext cx="298448" cy="61912"/>
              <a:chOff x="1066800" y="762000"/>
              <a:chExt cx="1268918" cy="493301"/>
            </a:xfrm>
          </p:grpSpPr>
          <p:sp>
            <p:nvSpPr>
              <p:cNvPr id="276" name="Freihandform 275"/>
              <p:cNvSpPr/>
              <p:nvPr/>
            </p:nvSpPr>
            <p:spPr>
              <a:xfrm>
                <a:off x="1080225" y="755211"/>
                <a:ext cx="1181172" cy="455358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7" name="Freihandform 276"/>
              <p:cNvSpPr/>
              <p:nvPr/>
            </p:nvSpPr>
            <p:spPr>
              <a:xfrm rot="10586904">
                <a:off x="1166376" y="788843"/>
                <a:ext cx="1181176" cy="455358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78" name="Gerade Verbindung 277"/>
              <p:cNvCxnSpPr/>
              <p:nvPr/>
            </p:nvCxnSpPr>
            <p:spPr>
              <a:xfrm>
                <a:off x="1225228" y="910456"/>
                <a:ext cx="148490" cy="75893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9" name="Gerade Verbindung 278"/>
              <p:cNvCxnSpPr>
                <a:stCxn id="277" idx="2"/>
              </p:cNvCxnSpPr>
              <p:nvPr/>
            </p:nvCxnSpPr>
            <p:spPr>
              <a:xfrm rot="10800000" flipV="1">
                <a:off x="1608053" y="807768"/>
                <a:ext cx="33746" cy="25297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0" name="Gerade Verbindung 279"/>
              <p:cNvCxnSpPr/>
              <p:nvPr/>
            </p:nvCxnSpPr>
            <p:spPr>
              <a:xfrm rot="16200000" flipH="1">
                <a:off x="1646282" y="1014286"/>
                <a:ext cx="227679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Gerade Verbindung 280"/>
              <p:cNvCxnSpPr>
                <a:endCxn id="277" idx="1"/>
              </p:cNvCxnSpPr>
              <p:nvPr/>
            </p:nvCxnSpPr>
            <p:spPr>
              <a:xfrm rot="5400000">
                <a:off x="1942559" y="1054793"/>
                <a:ext cx="303572" cy="13499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5" name="Gruppieren 216"/>
            <p:cNvGrpSpPr>
              <a:grpSpLocks/>
            </p:cNvGrpSpPr>
            <p:nvPr/>
          </p:nvGrpSpPr>
          <p:grpSpPr bwMode="auto">
            <a:xfrm rot="19107902">
              <a:off x="8666344" y="4092594"/>
              <a:ext cx="360361" cy="125411"/>
              <a:chOff x="1524000" y="914400"/>
              <a:chExt cx="2133600" cy="609600"/>
            </a:xfrm>
          </p:grpSpPr>
          <p:sp>
            <p:nvSpPr>
              <p:cNvPr id="269" name="Ellipse 268"/>
              <p:cNvSpPr/>
              <p:nvPr/>
            </p:nvSpPr>
            <p:spPr>
              <a:xfrm>
                <a:off x="1821880" y="912262"/>
                <a:ext cx="310168" cy="308659"/>
              </a:xfrm>
              <a:prstGeom prst="ellipse">
                <a:avLst/>
              </a:prstGeom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0" name="Ellipse 269"/>
              <p:cNvSpPr/>
              <p:nvPr/>
            </p:nvSpPr>
            <p:spPr>
              <a:xfrm>
                <a:off x="2131536" y="988422"/>
                <a:ext cx="300771" cy="300941"/>
              </a:xfrm>
              <a:prstGeom prst="ellipse">
                <a:avLst/>
              </a:prstGeom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1" name="Ellipse 270"/>
              <p:cNvSpPr/>
              <p:nvPr/>
            </p:nvSpPr>
            <p:spPr>
              <a:xfrm>
                <a:off x="2434304" y="1139860"/>
                <a:ext cx="310168" cy="300945"/>
              </a:xfrm>
              <a:prstGeom prst="ellipse">
                <a:avLst/>
              </a:prstGeom>
            </p:spPr>
            <p:style>
              <a:lnRef idx="1">
                <a:schemeClr val="dk1"/>
              </a:lnRef>
              <a:fillRef idx="3">
                <a:schemeClr val="dk1"/>
              </a:fillRef>
              <a:effectRef idx="2">
                <a:schemeClr val="dk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2" name="Ellipse 271"/>
              <p:cNvSpPr/>
              <p:nvPr/>
            </p:nvSpPr>
            <p:spPr>
              <a:xfrm>
                <a:off x="2747881" y="1220168"/>
                <a:ext cx="300771" cy="300945"/>
              </a:xfrm>
              <a:prstGeom prst="ellipse">
                <a:avLst/>
              </a:prstGeom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3" name="Ellipse 272"/>
              <p:cNvSpPr/>
              <p:nvPr/>
            </p:nvSpPr>
            <p:spPr>
              <a:xfrm>
                <a:off x="1525831" y="991197"/>
                <a:ext cx="300771" cy="300945"/>
              </a:xfrm>
              <a:prstGeom prst="ellipse">
                <a:avLst/>
              </a:prstGeom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4" name="Ellipse 273"/>
              <p:cNvSpPr/>
              <p:nvPr/>
            </p:nvSpPr>
            <p:spPr>
              <a:xfrm>
                <a:off x="3047041" y="1142201"/>
                <a:ext cx="310173" cy="300941"/>
              </a:xfrm>
              <a:prstGeom prst="ellipse">
                <a:avLst/>
              </a:prstGeom>
            </p:spPr>
            <p:style>
              <a:lnRef idx="1">
                <a:schemeClr val="accent3"/>
              </a:lnRef>
              <a:fillRef idx="3">
                <a:schemeClr val="accent3"/>
              </a:fillRef>
              <a:effectRef idx="2">
                <a:schemeClr val="accent3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5" name="Ellipse 274"/>
              <p:cNvSpPr/>
              <p:nvPr/>
            </p:nvSpPr>
            <p:spPr>
              <a:xfrm>
                <a:off x="3355604" y="1064230"/>
                <a:ext cx="300771" cy="300945"/>
              </a:xfrm>
              <a:prstGeom prst="ellipse">
                <a:avLst/>
              </a:prstGeom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26" name="Gruppieren 216"/>
            <p:cNvGrpSpPr>
              <a:grpSpLocks/>
            </p:cNvGrpSpPr>
            <p:nvPr/>
          </p:nvGrpSpPr>
          <p:grpSpPr bwMode="auto">
            <a:xfrm rot="15575701">
              <a:off x="9120368" y="4264044"/>
              <a:ext cx="352426" cy="127000"/>
              <a:chOff x="1524000" y="914400"/>
              <a:chExt cx="2133600" cy="609600"/>
            </a:xfrm>
          </p:grpSpPr>
          <p:sp>
            <p:nvSpPr>
              <p:cNvPr id="262" name="Ellipse 261"/>
              <p:cNvSpPr/>
              <p:nvPr/>
            </p:nvSpPr>
            <p:spPr>
              <a:xfrm>
                <a:off x="1847748" y="910580"/>
                <a:ext cx="297938" cy="304800"/>
              </a:xfrm>
              <a:prstGeom prst="ellipse">
                <a:avLst/>
              </a:prstGeom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3" name="Ellipse 262"/>
              <p:cNvSpPr/>
              <p:nvPr/>
            </p:nvSpPr>
            <p:spPr>
              <a:xfrm>
                <a:off x="2133767" y="983912"/>
                <a:ext cx="307546" cy="304800"/>
              </a:xfrm>
              <a:prstGeom prst="ellipse">
                <a:avLst/>
              </a:prstGeom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4" name="Ellipse 263"/>
              <p:cNvSpPr/>
              <p:nvPr/>
            </p:nvSpPr>
            <p:spPr>
              <a:xfrm>
                <a:off x="2440311" y="1137005"/>
                <a:ext cx="307546" cy="304800"/>
              </a:xfrm>
              <a:prstGeom prst="ellipse">
                <a:avLst/>
              </a:prstGeom>
            </p:spPr>
            <p:style>
              <a:lnRef idx="1">
                <a:schemeClr val="dk1"/>
              </a:lnRef>
              <a:fillRef idx="3">
                <a:schemeClr val="dk1"/>
              </a:fillRef>
              <a:effectRef idx="2">
                <a:schemeClr val="dk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5" name="Ellipse 264"/>
              <p:cNvSpPr/>
              <p:nvPr/>
            </p:nvSpPr>
            <p:spPr>
              <a:xfrm>
                <a:off x="2754762" y="1213775"/>
                <a:ext cx="307546" cy="304800"/>
              </a:xfrm>
              <a:prstGeom prst="ellipse">
                <a:avLst/>
              </a:prstGeom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6" name="Ellipse 265"/>
              <p:cNvSpPr/>
              <p:nvPr/>
            </p:nvSpPr>
            <p:spPr>
              <a:xfrm>
                <a:off x="1526867" y="988524"/>
                <a:ext cx="307546" cy="304800"/>
              </a:xfrm>
              <a:prstGeom prst="ellipse">
                <a:avLst/>
              </a:prstGeom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7" name="Ellipse 266"/>
              <p:cNvSpPr/>
              <p:nvPr/>
            </p:nvSpPr>
            <p:spPr>
              <a:xfrm>
                <a:off x="3064457" y="1141952"/>
                <a:ext cx="297938" cy="304800"/>
              </a:xfrm>
              <a:prstGeom prst="ellipse">
                <a:avLst/>
              </a:prstGeom>
            </p:spPr>
            <p:style>
              <a:lnRef idx="1">
                <a:schemeClr val="accent3"/>
              </a:lnRef>
              <a:fillRef idx="3">
                <a:schemeClr val="accent3"/>
              </a:fillRef>
              <a:effectRef idx="2">
                <a:schemeClr val="accent3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8" name="Ellipse 267"/>
              <p:cNvSpPr/>
              <p:nvPr/>
            </p:nvSpPr>
            <p:spPr>
              <a:xfrm>
                <a:off x="3356830" y="1061261"/>
                <a:ext cx="307546" cy="304800"/>
              </a:xfrm>
              <a:prstGeom prst="ellipse">
                <a:avLst/>
              </a:prstGeom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27" name="Gruppieren 216"/>
            <p:cNvGrpSpPr>
              <a:grpSpLocks/>
            </p:cNvGrpSpPr>
            <p:nvPr/>
          </p:nvGrpSpPr>
          <p:grpSpPr bwMode="auto">
            <a:xfrm rot="21249679">
              <a:off x="8807633" y="4422795"/>
              <a:ext cx="361949" cy="123826"/>
              <a:chOff x="1524000" y="914400"/>
              <a:chExt cx="2133600" cy="609600"/>
            </a:xfrm>
          </p:grpSpPr>
          <p:sp>
            <p:nvSpPr>
              <p:cNvPr id="255" name="Ellipse 254"/>
              <p:cNvSpPr/>
              <p:nvPr/>
            </p:nvSpPr>
            <p:spPr>
              <a:xfrm>
                <a:off x="1830196" y="908572"/>
                <a:ext cx="299453" cy="304798"/>
              </a:xfrm>
              <a:prstGeom prst="ellipse">
                <a:avLst/>
              </a:prstGeom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6" name="Ellipse 255"/>
              <p:cNvSpPr/>
              <p:nvPr/>
            </p:nvSpPr>
            <p:spPr>
              <a:xfrm>
                <a:off x="2130719" y="989627"/>
                <a:ext cx="308808" cy="304802"/>
              </a:xfrm>
              <a:prstGeom prst="ellipse">
                <a:avLst/>
              </a:prstGeom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7" name="Ellipse 256"/>
              <p:cNvSpPr/>
              <p:nvPr/>
            </p:nvSpPr>
            <p:spPr>
              <a:xfrm>
                <a:off x="2442289" y="1133681"/>
                <a:ext cx="299453" cy="304798"/>
              </a:xfrm>
              <a:prstGeom prst="ellipse">
                <a:avLst/>
              </a:prstGeom>
            </p:spPr>
            <p:style>
              <a:lnRef idx="1">
                <a:schemeClr val="dk1"/>
              </a:lnRef>
              <a:fillRef idx="3">
                <a:schemeClr val="dk1"/>
              </a:fillRef>
              <a:effectRef idx="2">
                <a:schemeClr val="dk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8" name="Ellipse 257"/>
              <p:cNvSpPr/>
              <p:nvPr/>
            </p:nvSpPr>
            <p:spPr>
              <a:xfrm>
                <a:off x="2733500" y="1213941"/>
                <a:ext cx="308813" cy="304802"/>
              </a:xfrm>
              <a:prstGeom prst="ellipse">
                <a:avLst/>
              </a:prstGeom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9" name="Ellipse 258"/>
              <p:cNvSpPr/>
              <p:nvPr/>
            </p:nvSpPr>
            <p:spPr>
              <a:xfrm>
                <a:off x="1519897" y="984598"/>
                <a:ext cx="308813" cy="304802"/>
              </a:xfrm>
              <a:prstGeom prst="ellipse">
                <a:avLst/>
              </a:prstGeom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0" name="Ellipse 259"/>
              <p:cNvSpPr/>
              <p:nvPr/>
            </p:nvSpPr>
            <p:spPr>
              <a:xfrm>
                <a:off x="3043799" y="1137915"/>
                <a:ext cx="299453" cy="304798"/>
              </a:xfrm>
              <a:prstGeom prst="ellipse">
                <a:avLst/>
              </a:prstGeom>
            </p:spPr>
            <p:style>
              <a:lnRef idx="1">
                <a:schemeClr val="accent3"/>
              </a:lnRef>
              <a:fillRef idx="3">
                <a:schemeClr val="accent3"/>
              </a:fillRef>
              <a:effectRef idx="2">
                <a:schemeClr val="accent3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1" name="Ellipse 260"/>
              <p:cNvSpPr/>
              <p:nvPr/>
            </p:nvSpPr>
            <p:spPr>
              <a:xfrm>
                <a:off x="3343791" y="1069661"/>
                <a:ext cx="308808" cy="304798"/>
              </a:xfrm>
              <a:prstGeom prst="ellipse">
                <a:avLst/>
              </a:prstGeom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28" name="Gruppieren 105"/>
            <p:cNvGrpSpPr>
              <a:grpSpLocks/>
            </p:cNvGrpSpPr>
            <p:nvPr/>
          </p:nvGrpSpPr>
          <p:grpSpPr bwMode="auto">
            <a:xfrm rot="15324467">
              <a:off x="8490926" y="4341037"/>
              <a:ext cx="298450" cy="61913"/>
              <a:chOff x="1066800" y="762000"/>
              <a:chExt cx="1268918" cy="493301"/>
            </a:xfrm>
          </p:grpSpPr>
          <p:sp>
            <p:nvSpPr>
              <p:cNvPr id="249" name="Freihandform 248"/>
              <p:cNvSpPr/>
              <p:nvPr/>
            </p:nvSpPr>
            <p:spPr>
              <a:xfrm>
                <a:off x="1075598" y="757326"/>
                <a:ext cx="1181172" cy="455351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0" name="Freihandform 249"/>
              <p:cNvSpPr/>
              <p:nvPr/>
            </p:nvSpPr>
            <p:spPr>
              <a:xfrm rot="10586904">
                <a:off x="1167043" y="801939"/>
                <a:ext cx="1181172" cy="455351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51" name="Gerade Verbindung 250"/>
              <p:cNvCxnSpPr/>
              <p:nvPr/>
            </p:nvCxnSpPr>
            <p:spPr>
              <a:xfrm>
                <a:off x="1223778" y="911215"/>
                <a:ext cx="148490" cy="75892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2" name="Gerade Verbindung 251"/>
              <p:cNvCxnSpPr>
                <a:stCxn id="250" idx="2"/>
              </p:cNvCxnSpPr>
              <p:nvPr/>
            </p:nvCxnSpPr>
            <p:spPr>
              <a:xfrm rot="10800000" flipV="1">
                <a:off x="1606987" y="811722"/>
                <a:ext cx="33746" cy="252973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3" name="Gerade Verbindung 252"/>
              <p:cNvCxnSpPr/>
              <p:nvPr/>
            </p:nvCxnSpPr>
            <p:spPr>
              <a:xfrm rot="16200000" flipH="1">
                <a:off x="1642225" y="1015780"/>
                <a:ext cx="227676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4" name="Gerade Verbindung 253"/>
              <p:cNvCxnSpPr>
                <a:endCxn id="250" idx="1"/>
              </p:cNvCxnSpPr>
              <p:nvPr/>
            </p:nvCxnSpPr>
            <p:spPr>
              <a:xfrm rot="5400000">
                <a:off x="1946178" y="1058199"/>
                <a:ext cx="303567" cy="13499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29" name="Picture 2" descr="y:\Dokumente\Ergebnisse\Flureszenzmarkierte Partikel\Cell Subsets\Bild4.png"/>
            <p:cNvPicPr>
              <a:picLocks noChangeAspect="1" noChangeArrowheads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9697" b="16383"/>
            <a:stretch>
              <a:fillRect/>
            </a:stretch>
          </p:blipFill>
          <p:spPr bwMode="auto">
            <a:xfrm>
              <a:off x="8713968" y="4011631"/>
              <a:ext cx="184149" cy="1333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30" name="Picture 5" descr="y:\Dokumente\Ergebnisse\Flureszenzmarkierte Partikel\Cell Subsets\Bild4.png"/>
            <p:cNvPicPr>
              <a:picLocks noChangeAspect="1" noChangeArrowheads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284" t="9213"/>
            <a:stretch>
              <a:fillRect/>
            </a:stretch>
          </p:blipFill>
          <p:spPr bwMode="auto">
            <a:xfrm rot="15401881">
              <a:off x="9718847" y="3817952"/>
              <a:ext cx="184150" cy="149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31" name="Picture 7" descr="y:\Dokumente\Ergebnisse\Flureszenzmarkierte Partikel\Cell Subsets\Bild4.png"/>
            <p:cNvPicPr>
              <a:picLocks noChangeAspect="1" noChangeArrowheads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0262"/>
            <a:stretch>
              <a:fillRect/>
            </a:stretch>
          </p:blipFill>
          <p:spPr bwMode="auto">
            <a:xfrm rot="20107108">
              <a:off x="9464853" y="4914919"/>
              <a:ext cx="304798" cy="63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32" name="Picture 8" descr="y:\Dokumente\Ergebnisse\Flureszenzmarkierte Partikel\Cell Subsets\Bild5.png"/>
            <p:cNvPicPr>
              <a:picLocks noChangeAspect="1" noChangeArrowheads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97" t="63007"/>
            <a:stretch>
              <a:fillRect/>
            </a:stretch>
          </p:blipFill>
          <p:spPr bwMode="auto">
            <a:xfrm rot="15717846">
              <a:off x="8925898" y="4215622"/>
              <a:ext cx="158751" cy="1571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33" name="Picture 10" descr="y:\Dokumente\Ergebnisse\Flureszenzmarkierte Partikel\Cell Subsets\Bild5.png"/>
            <p:cNvPicPr>
              <a:picLocks noChangeAspect="1" noChangeArrowheads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309" t="23836" r="23225" b="18491"/>
            <a:stretch>
              <a:fillRect/>
            </a:stretch>
          </p:blipFill>
          <p:spPr bwMode="auto">
            <a:xfrm rot="1426321">
              <a:off x="9158464" y="3935432"/>
              <a:ext cx="106362" cy="238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34" name="Gruppieren 105"/>
            <p:cNvGrpSpPr>
              <a:grpSpLocks/>
            </p:cNvGrpSpPr>
            <p:nvPr/>
          </p:nvGrpSpPr>
          <p:grpSpPr bwMode="auto">
            <a:xfrm rot="12567120">
              <a:off x="8798097" y="4238645"/>
              <a:ext cx="306384" cy="60324"/>
              <a:chOff x="1066800" y="762000"/>
              <a:chExt cx="1268918" cy="493301"/>
            </a:xfrm>
          </p:grpSpPr>
          <p:sp>
            <p:nvSpPr>
              <p:cNvPr id="243" name="Freihandform 242"/>
              <p:cNvSpPr/>
              <p:nvPr/>
            </p:nvSpPr>
            <p:spPr>
              <a:xfrm>
                <a:off x="1072884" y="773823"/>
                <a:ext cx="1176872" cy="454360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4" name="Freihandform 243"/>
              <p:cNvSpPr/>
              <p:nvPr/>
            </p:nvSpPr>
            <p:spPr>
              <a:xfrm rot="10586904">
                <a:off x="1168185" y="816650"/>
                <a:ext cx="1176876" cy="454360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45" name="Gerade Verbindung 244"/>
              <p:cNvCxnSpPr/>
              <p:nvPr/>
            </p:nvCxnSpPr>
            <p:spPr>
              <a:xfrm>
                <a:off x="1221266" y="928593"/>
                <a:ext cx="151221" cy="7789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6" name="Gerade Verbindung 245"/>
              <p:cNvCxnSpPr>
                <a:stCxn id="244" idx="2"/>
              </p:cNvCxnSpPr>
              <p:nvPr/>
            </p:nvCxnSpPr>
            <p:spPr>
              <a:xfrm rot="10800000" flipV="1">
                <a:off x="1608312" y="829001"/>
                <a:ext cx="32872" cy="24665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7" name="Gerade Verbindung 246"/>
              <p:cNvCxnSpPr/>
              <p:nvPr/>
            </p:nvCxnSpPr>
            <p:spPr>
              <a:xfrm rot="16200000" flipH="1">
                <a:off x="1646281" y="1040544"/>
                <a:ext cx="220683" cy="6573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8" name="Gerade Verbindung 247"/>
              <p:cNvCxnSpPr>
                <a:endCxn id="244" idx="1"/>
              </p:cNvCxnSpPr>
              <p:nvPr/>
            </p:nvCxnSpPr>
            <p:spPr>
              <a:xfrm rot="5400000">
                <a:off x="1949751" y="1069627"/>
                <a:ext cx="298581" cy="19726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35" name="Picture 11" descr="y:\Dokumente\Ergebnisse\Flureszenzmarkierte Partikel\Cell Subsets\Bild4.png"/>
            <p:cNvPicPr>
              <a:picLocks noChangeAspect="1" noChangeArrowheads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792" t="55826"/>
            <a:stretch>
              <a:fillRect/>
            </a:stretch>
          </p:blipFill>
          <p:spPr bwMode="auto">
            <a:xfrm rot="20556710">
              <a:off x="9063209" y="4567258"/>
              <a:ext cx="169861" cy="603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36" name="Gruppieren 105"/>
            <p:cNvGrpSpPr>
              <a:grpSpLocks/>
            </p:cNvGrpSpPr>
            <p:nvPr/>
          </p:nvGrpSpPr>
          <p:grpSpPr bwMode="auto">
            <a:xfrm rot="15801701">
              <a:off x="8998172" y="4464065"/>
              <a:ext cx="300038" cy="61913"/>
              <a:chOff x="1066800" y="762000"/>
              <a:chExt cx="1268918" cy="493301"/>
            </a:xfrm>
          </p:grpSpPr>
          <p:sp>
            <p:nvSpPr>
              <p:cNvPr id="237" name="Freihandform 236"/>
              <p:cNvSpPr/>
              <p:nvPr/>
            </p:nvSpPr>
            <p:spPr>
              <a:xfrm>
                <a:off x="1061588" y="751157"/>
                <a:ext cx="1181636" cy="455351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8" name="Freihandform 237"/>
              <p:cNvSpPr/>
              <p:nvPr/>
            </p:nvSpPr>
            <p:spPr>
              <a:xfrm rot="10586904">
                <a:off x="1153400" y="796755"/>
                <a:ext cx="1181636" cy="455351"/>
              </a:xfrm>
              <a:custGeom>
                <a:avLst/>
                <a:gdLst>
                  <a:gd name="connsiteX0" fmla="*/ 0 w 1179689"/>
                  <a:gd name="connsiteY0" fmla="*/ 438385 h 457200"/>
                  <a:gd name="connsiteX1" fmla="*/ 259644 w 1179689"/>
                  <a:gd name="connsiteY1" fmla="*/ 20696 h 457200"/>
                  <a:gd name="connsiteX2" fmla="*/ 688622 w 1179689"/>
                  <a:gd name="connsiteY2" fmla="*/ 449674 h 457200"/>
                  <a:gd name="connsiteX3" fmla="*/ 1106311 w 1179689"/>
                  <a:gd name="connsiteY3" fmla="*/ 65852 h 457200"/>
                  <a:gd name="connsiteX4" fmla="*/ 1128889 w 1179689"/>
                  <a:gd name="connsiteY4" fmla="*/ 54563 h 457200"/>
                  <a:gd name="connsiteX5" fmla="*/ 1106311 w 1179689"/>
                  <a:gd name="connsiteY5" fmla="*/ 54563 h 457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179689" h="457200">
                    <a:moveTo>
                      <a:pt x="0" y="438385"/>
                    </a:moveTo>
                    <a:cubicBezTo>
                      <a:pt x="72437" y="228600"/>
                      <a:pt x="144874" y="18815"/>
                      <a:pt x="259644" y="20696"/>
                    </a:cubicBezTo>
                    <a:cubicBezTo>
                      <a:pt x="374414" y="22578"/>
                      <a:pt x="547511" y="442148"/>
                      <a:pt x="688622" y="449674"/>
                    </a:cubicBezTo>
                    <a:cubicBezTo>
                      <a:pt x="829733" y="457200"/>
                      <a:pt x="1032933" y="131704"/>
                      <a:pt x="1106311" y="65852"/>
                    </a:cubicBezTo>
                    <a:cubicBezTo>
                      <a:pt x="1179689" y="0"/>
                      <a:pt x="1128889" y="56444"/>
                      <a:pt x="1128889" y="54563"/>
                    </a:cubicBezTo>
                    <a:cubicBezTo>
                      <a:pt x="1128889" y="52682"/>
                      <a:pt x="1117600" y="53622"/>
                      <a:pt x="1106311" y="54563"/>
                    </a:cubicBezTo>
                  </a:path>
                </a:pathLst>
              </a:cu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de-DE" sz="105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39" name="Gerade Verbindung 238"/>
              <p:cNvCxnSpPr/>
              <p:nvPr/>
            </p:nvCxnSpPr>
            <p:spPr>
              <a:xfrm>
                <a:off x="1215330" y="912186"/>
                <a:ext cx="147704" cy="75892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0" name="Gerade Verbindung 239"/>
              <p:cNvCxnSpPr>
                <a:stCxn id="238" idx="2"/>
              </p:cNvCxnSpPr>
              <p:nvPr/>
            </p:nvCxnSpPr>
            <p:spPr>
              <a:xfrm rot="10800000" flipV="1">
                <a:off x="1601269" y="806611"/>
                <a:ext cx="33567" cy="252973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1" name="Gerade Verbindung 240"/>
              <p:cNvCxnSpPr/>
              <p:nvPr/>
            </p:nvCxnSpPr>
            <p:spPr>
              <a:xfrm rot="16200000" flipH="1">
                <a:off x="1647051" y="1024734"/>
                <a:ext cx="227676" cy="6712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Gerade Verbindung 241"/>
              <p:cNvCxnSpPr>
                <a:endCxn id="238" idx="1"/>
              </p:cNvCxnSpPr>
              <p:nvPr/>
            </p:nvCxnSpPr>
            <p:spPr>
              <a:xfrm rot="5400000">
                <a:off x="1941539" y="1056063"/>
                <a:ext cx="303567" cy="13428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60" name="Gruppieren 140"/>
          <p:cNvGrpSpPr>
            <a:grpSpLocks/>
          </p:cNvGrpSpPr>
          <p:nvPr/>
        </p:nvGrpSpPr>
        <p:grpSpPr bwMode="auto">
          <a:xfrm rot="1505681">
            <a:off x="2128237" y="1029932"/>
            <a:ext cx="229926" cy="46165"/>
            <a:chOff x="1060415" y="754604"/>
            <a:chExt cx="1273472" cy="498114"/>
          </a:xfrm>
        </p:grpSpPr>
        <p:sp>
          <p:nvSpPr>
            <p:cNvPr id="361" name="Freihandform 360"/>
            <p:cNvSpPr/>
            <p:nvPr/>
          </p:nvSpPr>
          <p:spPr>
            <a:xfrm>
              <a:off x="1060415" y="754604"/>
              <a:ext cx="1182235" cy="458860"/>
            </a:xfrm>
            <a:custGeom>
              <a:avLst/>
              <a:gdLst>
                <a:gd name="connsiteX0" fmla="*/ 0 w 1179689"/>
                <a:gd name="connsiteY0" fmla="*/ 438385 h 457200"/>
                <a:gd name="connsiteX1" fmla="*/ 259644 w 1179689"/>
                <a:gd name="connsiteY1" fmla="*/ 20696 h 457200"/>
                <a:gd name="connsiteX2" fmla="*/ 688622 w 1179689"/>
                <a:gd name="connsiteY2" fmla="*/ 449674 h 457200"/>
                <a:gd name="connsiteX3" fmla="*/ 1106311 w 1179689"/>
                <a:gd name="connsiteY3" fmla="*/ 65852 h 457200"/>
                <a:gd name="connsiteX4" fmla="*/ 1128889 w 1179689"/>
                <a:gd name="connsiteY4" fmla="*/ 54563 h 457200"/>
                <a:gd name="connsiteX5" fmla="*/ 1106311 w 1179689"/>
                <a:gd name="connsiteY5" fmla="*/ 54563 h 457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179689" h="457200">
                  <a:moveTo>
                    <a:pt x="0" y="438385"/>
                  </a:moveTo>
                  <a:cubicBezTo>
                    <a:pt x="72437" y="228600"/>
                    <a:pt x="144874" y="18815"/>
                    <a:pt x="259644" y="20696"/>
                  </a:cubicBezTo>
                  <a:cubicBezTo>
                    <a:pt x="374414" y="22578"/>
                    <a:pt x="547511" y="442148"/>
                    <a:pt x="688622" y="449674"/>
                  </a:cubicBezTo>
                  <a:cubicBezTo>
                    <a:pt x="829733" y="457200"/>
                    <a:pt x="1032933" y="131704"/>
                    <a:pt x="1106311" y="65852"/>
                  </a:cubicBezTo>
                  <a:cubicBezTo>
                    <a:pt x="1179689" y="0"/>
                    <a:pt x="1128889" y="56444"/>
                    <a:pt x="1128889" y="54563"/>
                  </a:cubicBezTo>
                  <a:cubicBezTo>
                    <a:pt x="1128889" y="52682"/>
                    <a:pt x="1117600" y="53622"/>
                    <a:pt x="1106311" y="54563"/>
                  </a:cubicBezTo>
                </a:path>
              </a:pathLst>
            </a:cu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2" name="Freihandform 361"/>
            <p:cNvSpPr/>
            <p:nvPr/>
          </p:nvSpPr>
          <p:spPr>
            <a:xfrm rot="10586904">
              <a:off x="1151652" y="793858"/>
              <a:ext cx="1182235" cy="458860"/>
            </a:xfrm>
            <a:custGeom>
              <a:avLst/>
              <a:gdLst>
                <a:gd name="connsiteX0" fmla="*/ 0 w 1179689"/>
                <a:gd name="connsiteY0" fmla="*/ 438385 h 457200"/>
                <a:gd name="connsiteX1" fmla="*/ 259644 w 1179689"/>
                <a:gd name="connsiteY1" fmla="*/ 20696 h 457200"/>
                <a:gd name="connsiteX2" fmla="*/ 688622 w 1179689"/>
                <a:gd name="connsiteY2" fmla="*/ 449674 h 457200"/>
                <a:gd name="connsiteX3" fmla="*/ 1106311 w 1179689"/>
                <a:gd name="connsiteY3" fmla="*/ 65852 h 457200"/>
                <a:gd name="connsiteX4" fmla="*/ 1128889 w 1179689"/>
                <a:gd name="connsiteY4" fmla="*/ 54563 h 457200"/>
                <a:gd name="connsiteX5" fmla="*/ 1106311 w 1179689"/>
                <a:gd name="connsiteY5" fmla="*/ 54563 h 457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179689" h="457200">
                  <a:moveTo>
                    <a:pt x="0" y="438385"/>
                  </a:moveTo>
                  <a:cubicBezTo>
                    <a:pt x="72437" y="228600"/>
                    <a:pt x="144874" y="18815"/>
                    <a:pt x="259644" y="20696"/>
                  </a:cubicBezTo>
                  <a:cubicBezTo>
                    <a:pt x="374414" y="22578"/>
                    <a:pt x="547511" y="442148"/>
                    <a:pt x="688622" y="449674"/>
                  </a:cubicBezTo>
                  <a:cubicBezTo>
                    <a:pt x="829733" y="457200"/>
                    <a:pt x="1032933" y="131704"/>
                    <a:pt x="1106311" y="65852"/>
                  </a:cubicBezTo>
                  <a:cubicBezTo>
                    <a:pt x="1179689" y="0"/>
                    <a:pt x="1128889" y="56444"/>
                    <a:pt x="1128889" y="54563"/>
                  </a:cubicBezTo>
                  <a:cubicBezTo>
                    <a:pt x="1128889" y="52682"/>
                    <a:pt x="1117600" y="53622"/>
                    <a:pt x="1106311" y="54563"/>
                  </a:cubicBezTo>
                </a:path>
              </a:pathLst>
            </a:cu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63" name="Gerade Verbindung 362"/>
            <p:cNvCxnSpPr/>
            <p:nvPr/>
          </p:nvCxnSpPr>
          <p:spPr>
            <a:xfrm>
              <a:off x="1215944" y="905917"/>
              <a:ext cx="149865" cy="79424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4" name="Gerade Verbindung 363"/>
            <p:cNvCxnSpPr>
              <a:stCxn id="362" idx="2"/>
            </p:cNvCxnSpPr>
            <p:nvPr/>
          </p:nvCxnSpPr>
          <p:spPr>
            <a:xfrm rot="10800000" flipV="1">
              <a:off x="1592253" y="805011"/>
              <a:ext cx="33304" cy="25589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5" name="Gerade Verbindung 364"/>
            <p:cNvCxnSpPr/>
            <p:nvPr/>
          </p:nvCxnSpPr>
          <p:spPr>
            <a:xfrm rot="16200000" flipH="1">
              <a:off x="1638820" y="1013673"/>
              <a:ext cx="220609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6" name="Gerade Verbindung 365"/>
            <p:cNvCxnSpPr>
              <a:endCxn id="362" idx="1"/>
            </p:cNvCxnSpPr>
            <p:nvPr/>
          </p:nvCxnSpPr>
          <p:spPr>
            <a:xfrm rot="5400000">
              <a:off x="1939845" y="1048867"/>
              <a:ext cx="300022" cy="16649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7" name="Gruppieren 216"/>
          <p:cNvGrpSpPr>
            <a:grpSpLocks/>
          </p:cNvGrpSpPr>
          <p:nvPr/>
        </p:nvGrpSpPr>
        <p:grpSpPr bwMode="auto">
          <a:xfrm rot="19107902">
            <a:off x="2152542" y="1254932"/>
            <a:ext cx="224703" cy="113342"/>
            <a:chOff x="1515490" y="911074"/>
            <a:chExt cx="2139252" cy="609805"/>
          </a:xfrm>
        </p:grpSpPr>
        <p:sp>
          <p:nvSpPr>
            <p:cNvPr id="368" name="Ellipse 367"/>
            <p:cNvSpPr/>
            <p:nvPr/>
          </p:nvSpPr>
          <p:spPr>
            <a:xfrm>
              <a:off x="1830658" y="911074"/>
              <a:ext cx="305394" cy="31018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9" name="Ellipse 368"/>
            <p:cNvSpPr/>
            <p:nvPr/>
          </p:nvSpPr>
          <p:spPr>
            <a:xfrm>
              <a:off x="2128408" y="988301"/>
              <a:ext cx="305394" cy="302230"/>
            </a:xfrm>
            <a:prstGeom prst="ellipse">
              <a:avLst/>
            </a:prstGeom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0" name="Ellipse 369"/>
            <p:cNvSpPr/>
            <p:nvPr/>
          </p:nvSpPr>
          <p:spPr>
            <a:xfrm>
              <a:off x="2436889" y="1134524"/>
              <a:ext cx="295217" cy="302230"/>
            </a:xfrm>
            <a:prstGeom prst="ellipse">
              <a:avLst/>
            </a:prstGeom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1" name="Ellipse 370"/>
            <p:cNvSpPr/>
            <p:nvPr/>
          </p:nvSpPr>
          <p:spPr>
            <a:xfrm>
              <a:off x="2737595" y="1218650"/>
              <a:ext cx="305394" cy="302229"/>
            </a:xfrm>
            <a:prstGeom prst="ellipse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2" name="Ellipse 371"/>
            <p:cNvSpPr/>
            <p:nvPr/>
          </p:nvSpPr>
          <p:spPr>
            <a:xfrm>
              <a:off x="1515490" y="989111"/>
              <a:ext cx="305394" cy="302228"/>
            </a:xfrm>
            <a:prstGeom prst="ellipse">
              <a:avLst/>
            </a:prstGeom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3" name="Ellipse 372"/>
            <p:cNvSpPr/>
            <p:nvPr/>
          </p:nvSpPr>
          <p:spPr>
            <a:xfrm>
              <a:off x="3041793" y="1142281"/>
              <a:ext cx="305396" cy="302229"/>
            </a:xfrm>
            <a:prstGeom prst="ellipse">
              <a:avLst/>
            </a:prstGeom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4" name="Ellipse 373"/>
            <p:cNvSpPr/>
            <p:nvPr/>
          </p:nvSpPr>
          <p:spPr>
            <a:xfrm>
              <a:off x="3349346" y="1058959"/>
              <a:ext cx="305396" cy="310186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75" name="Ellipse 374"/>
          <p:cNvSpPr/>
          <p:nvPr/>
        </p:nvSpPr>
        <p:spPr bwMode="auto">
          <a:xfrm>
            <a:off x="2136250" y="612636"/>
            <a:ext cx="201600" cy="201457"/>
          </a:xfrm>
          <a:prstGeom prst="ellipse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  <a:effectLst>
            <a:outerShdw blurRad="50800" dist="38100" algn="l" rotWithShape="0">
              <a:prstClr val="black">
                <a:alpha val="40000"/>
              </a:prstClr>
            </a:outerShdw>
          </a:effectLst>
          <a:scene3d>
            <a:camera prst="orthographicFront"/>
            <a:lightRig rig="threePt" dir="t"/>
          </a:scene3d>
          <a:sp3d>
            <a:bevelT w="1905000" h="1905000"/>
          </a:sp3d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1050">
              <a:latin typeface="Arial" pitchFamily="34" charset="0"/>
              <a:cs typeface="Arial" pitchFamily="34" charset="0"/>
            </a:endParaRPr>
          </a:p>
        </p:txBody>
      </p:sp>
      <p:sp>
        <p:nvSpPr>
          <p:cNvPr id="376" name="Textfeld 375"/>
          <p:cNvSpPr txBox="1"/>
          <p:nvPr/>
        </p:nvSpPr>
        <p:spPr>
          <a:xfrm>
            <a:off x="2445237" y="574757"/>
            <a:ext cx="614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CaP</a:t>
            </a:r>
            <a:r>
              <a:rPr lang="de-DE" sz="8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core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7" name="Textfeld 376"/>
          <p:cNvSpPr txBox="1"/>
          <p:nvPr/>
        </p:nvSpPr>
        <p:spPr>
          <a:xfrm>
            <a:off x="2445237" y="906652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CpG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8" name="Textfeld 377"/>
          <p:cNvSpPr txBox="1"/>
          <p:nvPr/>
        </p:nvSpPr>
        <p:spPr>
          <a:xfrm>
            <a:off x="2445237" y="1165059"/>
            <a:ext cx="6687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GagL</a:t>
            </a:r>
            <a:r>
              <a:rPr lang="en-US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85-93</a:t>
            </a:r>
            <a:endParaRPr lang="de-DE" sz="800" dirty="0" smtClean="0">
              <a:latin typeface="Arial" pitchFamily="34" charset="0"/>
              <a:cs typeface="Arial" pitchFamily="34" charset="0"/>
            </a:endParaRPr>
          </a:p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gp70</a:t>
            </a:r>
            <a:r>
              <a:rPr lang="en-US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123-141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79" name="Gruppieren 216"/>
          <p:cNvGrpSpPr>
            <a:grpSpLocks/>
          </p:cNvGrpSpPr>
          <p:nvPr/>
        </p:nvGrpSpPr>
        <p:grpSpPr bwMode="auto">
          <a:xfrm rot="12756514">
            <a:off x="2258756" y="1390313"/>
            <a:ext cx="224703" cy="113342"/>
            <a:chOff x="1515490" y="911074"/>
            <a:chExt cx="2139252" cy="609805"/>
          </a:xfrm>
        </p:grpSpPr>
        <p:sp>
          <p:nvSpPr>
            <p:cNvPr id="380" name="Ellipse 379"/>
            <p:cNvSpPr/>
            <p:nvPr/>
          </p:nvSpPr>
          <p:spPr>
            <a:xfrm>
              <a:off x="1830658" y="911074"/>
              <a:ext cx="305394" cy="31018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1" name="Ellipse 380"/>
            <p:cNvSpPr/>
            <p:nvPr/>
          </p:nvSpPr>
          <p:spPr>
            <a:xfrm>
              <a:off x="2128408" y="988301"/>
              <a:ext cx="305394" cy="302230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2" name="Ellipse 381"/>
            <p:cNvSpPr/>
            <p:nvPr/>
          </p:nvSpPr>
          <p:spPr>
            <a:xfrm>
              <a:off x="2436889" y="1134524"/>
              <a:ext cx="295217" cy="302230"/>
            </a:xfrm>
            <a:prstGeom prst="ellipse">
              <a:avLst/>
            </a:prstGeom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3" name="Ellipse 382"/>
            <p:cNvSpPr/>
            <p:nvPr/>
          </p:nvSpPr>
          <p:spPr>
            <a:xfrm>
              <a:off x="2737595" y="1218650"/>
              <a:ext cx="305394" cy="302229"/>
            </a:xfrm>
            <a:prstGeom prst="ellipse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4" name="Ellipse 383"/>
            <p:cNvSpPr/>
            <p:nvPr/>
          </p:nvSpPr>
          <p:spPr>
            <a:xfrm>
              <a:off x="1515490" y="989111"/>
              <a:ext cx="305394" cy="302228"/>
            </a:xfrm>
            <a:prstGeom prst="ellips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5" name="Ellipse 384"/>
            <p:cNvSpPr/>
            <p:nvPr/>
          </p:nvSpPr>
          <p:spPr>
            <a:xfrm>
              <a:off x="3041793" y="1142281"/>
              <a:ext cx="305396" cy="302229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6" name="Ellipse 385"/>
            <p:cNvSpPr/>
            <p:nvPr/>
          </p:nvSpPr>
          <p:spPr>
            <a:xfrm>
              <a:off x="3349346" y="1058959"/>
              <a:ext cx="305396" cy="310186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87" name="Textfeld 386"/>
          <p:cNvSpPr txBox="1"/>
          <p:nvPr/>
        </p:nvSpPr>
        <p:spPr>
          <a:xfrm>
            <a:off x="1288261" y="540132"/>
            <a:ext cx="5565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 smtClean="0">
                <a:latin typeface="Arial" pitchFamily="34" charset="0"/>
                <a:cs typeface="Arial" pitchFamily="34" charset="0"/>
              </a:rPr>
              <a:t>CaP</a:t>
            </a:r>
            <a:r>
              <a:rPr lang="de-DE" sz="800" b="1" dirty="0" smtClean="0">
                <a:latin typeface="Arial" pitchFamily="34" charset="0"/>
                <a:cs typeface="Arial" pitchFamily="34" charset="0"/>
              </a:rPr>
              <a:t> NP</a:t>
            </a:r>
            <a:endParaRPr lang="de-D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8" name="Textfeld 387"/>
          <p:cNvSpPr txBox="1"/>
          <p:nvPr/>
        </p:nvSpPr>
        <p:spPr>
          <a:xfrm>
            <a:off x="1452959" y="5796136"/>
            <a:ext cx="5245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.p.v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9" name="Textfeld 388"/>
          <p:cNvSpPr txBox="1"/>
          <p:nvPr/>
        </p:nvSpPr>
        <p:spPr>
          <a:xfrm>
            <a:off x="2443572" y="5796136"/>
            <a:ext cx="5822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14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.p.v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0" name="Textfeld 389"/>
          <p:cNvSpPr txBox="1"/>
          <p:nvPr/>
        </p:nvSpPr>
        <p:spPr>
          <a:xfrm>
            <a:off x="692696" y="557082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E</a:t>
            </a:r>
            <a:endParaRPr lang="de-DE" dirty="0"/>
          </a:p>
        </p:txBody>
      </p:sp>
      <p:sp>
        <p:nvSpPr>
          <p:cNvPr id="2" name="Rechteck 1"/>
          <p:cNvSpPr/>
          <p:nvPr/>
        </p:nvSpPr>
        <p:spPr>
          <a:xfrm>
            <a:off x="116632" y="7703184"/>
            <a:ext cx="6741368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) Schematic illustration of functionalized multi shell calcium phosphate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a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anoparticles. B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57BL/6 mice were chronically infected with FV (&gt;6 weeks) and therapeutically vaccinated either with PBS or functionalize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a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nanoparticles. 7 or 14 days post vaccination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d.p.v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), mice were sacrificed for analyzes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percentage of CD4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D4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CD8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D4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ffector cells is shown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requency of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granzym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B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Gzm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expressing CD4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D8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 cells and CD4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D8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FV-specific T cells identified by tetramer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ecognizing the H-2Db-restricted FV gag epitope i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epicted. E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 and 14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d.p.v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, mice were sacrificed, and infectious centers in the spleen were determined. The figure summarizes the results of 3 independent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s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atistical analysis was performed by student’s t-test. *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&lt;0.05;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p&lt;0.005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196574774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3</Words>
  <Application>Microsoft Office PowerPoint</Application>
  <PresentationFormat>Bildschirmpräsentation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Larissa</vt:lpstr>
      <vt:lpstr>Prism 6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nuschke, Torben</dc:creator>
  <cp:lastModifiedBy>Westendorf, Astrid</cp:lastModifiedBy>
  <cp:revision>239</cp:revision>
  <cp:lastPrinted>2016-01-27T10:34:07Z</cp:lastPrinted>
  <dcterms:created xsi:type="dcterms:W3CDTF">2014-07-03T11:02:25Z</dcterms:created>
  <dcterms:modified xsi:type="dcterms:W3CDTF">2016-03-21T09:56:57Z</dcterms:modified>
</cp:coreProperties>
</file>